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handoutMasterIdLst>
    <p:handoutMasterId r:id="rId4"/>
  </p:handoutMasterIdLst>
  <p:sldIdLst>
    <p:sldId id="1067" r:id="rId2"/>
  </p:sldIdLst>
  <p:sldSz cx="9906000" cy="6858000" type="A4"/>
  <p:notesSz cx="6858000" cy="9144000"/>
  <p:defaultTextStyle>
    <a:defPPr>
      <a:defRPr lang="it-IT"/>
    </a:defPPr>
    <a:lvl1pPr algn="l" rtl="0" fontAlgn="base">
      <a:spcBef>
        <a:spcPct val="0"/>
      </a:spcBef>
      <a:spcAft>
        <a:spcPct val="0"/>
      </a:spcAft>
      <a:defRPr sz="3200" b="1" kern="1200">
        <a:solidFill>
          <a:schemeClr val="tx1"/>
        </a:solidFill>
        <a:latin typeface="Times New Roman" pitchFamily="18" charset="0"/>
        <a:ea typeface="+mn-ea"/>
        <a:cs typeface="Arial" charset="0"/>
      </a:defRPr>
    </a:lvl1pPr>
    <a:lvl2pPr marL="457200" algn="l" rtl="0" fontAlgn="base">
      <a:spcBef>
        <a:spcPct val="0"/>
      </a:spcBef>
      <a:spcAft>
        <a:spcPct val="0"/>
      </a:spcAft>
      <a:defRPr sz="3200" b="1" kern="1200">
        <a:solidFill>
          <a:schemeClr val="tx1"/>
        </a:solidFill>
        <a:latin typeface="Times New Roman" pitchFamily="18" charset="0"/>
        <a:ea typeface="+mn-ea"/>
        <a:cs typeface="Arial" charset="0"/>
      </a:defRPr>
    </a:lvl2pPr>
    <a:lvl3pPr marL="914400" algn="l" rtl="0" fontAlgn="base">
      <a:spcBef>
        <a:spcPct val="0"/>
      </a:spcBef>
      <a:spcAft>
        <a:spcPct val="0"/>
      </a:spcAft>
      <a:defRPr sz="3200" b="1" kern="1200">
        <a:solidFill>
          <a:schemeClr val="tx1"/>
        </a:solidFill>
        <a:latin typeface="Times New Roman" pitchFamily="18" charset="0"/>
        <a:ea typeface="+mn-ea"/>
        <a:cs typeface="Arial" charset="0"/>
      </a:defRPr>
    </a:lvl3pPr>
    <a:lvl4pPr marL="1371600" algn="l" rtl="0" fontAlgn="base">
      <a:spcBef>
        <a:spcPct val="0"/>
      </a:spcBef>
      <a:spcAft>
        <a:spcPct val="0"/>
      </a:spcAft>
      <a:defRPr sz="3200" b="1" kern="1200">
        <a:solidFill>
          <a:schemeClr val="tx1"/>
        </a:solidFill>
        <a:latin typeface="Times New Roman" pitchFamily="18" charset="0"/>
        <a:ea typeface="+mn-ea"/>
        <a:cs typeface="Arial" charset="0"/>
      </a:defRPr>
    </a:lvl4pPr>
    <a:lvl5pPr marL="1828800" algn="l" rtl="0" fontAlgn="base">
      <a:spcBef>
        <a:spcPct val="0"/>
      </a:spcBef>
      <a:spcAft>
        <a:spcPct val="0"/>
      </a:spcAft>
      <a:defRPr sz="3200" b="1" kern="1200">
        <a:solidFill>
          <a:schemeClr val="tx1"/>
        </a:solidFill>
        <a:latin typeface="Times New Roman" pitchFamily="18" charset="0"/>
        <a:ea typeface="+mn-ea"/>
        <a:cs typeface="Arial" charset="0"/>
      </a:defRPr>
    </a:lvl5pPr>
    <a:lvl6pPr marL="2286000" algn="l" defTabSz="914400" rtl="0" eaLnBrk="1" latinLnBrk="0" hangingPunct="1">
      <a:defRPr sz="3200" b="1" kern="1200">
        <a:solidFill>
          <a:schemeClr val="tx1"/>
        </a:solidFill>
        <a:latin typeface="Times New Roman" pitchFamily="18" charset="0"/>
        <a:ea typeface="+mn-ea"/>
        <a:cs typeface="Arial" charset="0"/>
      </a:defRPr>
    </a:lvl6pPr>
    <a:lvl7pPr marL="2743200" algn="l" defTabSz="914400" rtl="0" eaLnBrk="1" latinLnBrk="0" hangingPunct="1">
      <a:defRPr sz="3200" b="1" kern="1200">
        <a:solidFill>
          <a:schemeClr val="tx1"/>
        </a:solidFill>
        <a:latin typeface="Times New Roman" pitchFamily="18" charset="0"/>
        <a:ea typeface="+mn-ea"/>
        <a:cs typeface="Arial" charset="0"/>
      </a:defRPr>
    </a:lvl7pPr>
    <a:lvl8pPr marL="3200400" algn="l" defTabSz="914400" rtl="0" eaLnBrk="1" latinLnBrk="0" hangingPunct="1">
      <a:defRPr sz="3200" b="1" kern="1200">
        <a:solidFill>
          <a:schemeClr val="tx1"/>
        </a:solidFill>
        <a:latin typeface="Times New Roman" pitchFamily="18" charset="0"/>
        <a:ea typeface="+mn-ea"/>
        <a:cs typeface="Arial" charset="0"/>
      </a:defRPr>
    </a:lvl8pPr>
    <a:lvl9pPr marL="3657600" algn="l" defTabSz="914400" rtl="0" eaLnBrk="1" latinLnBrk="0" hangingPunct="1">
      <a:defRPr sz="3200" b="1" kern="1200">
        <a:solidFill>
          <a:schemeClr val="tx1"/>
        </a:solidFill>
        <a:latin typeface="Times New Roman" pitchFamily="18" charset="0"/>
        <a:ea typeface="+mn-ea"/>
        <a:cs typeface="Arial" charset="0"/>
      </a:defRPr>
    </a:lvl9pPr>
  </p:defaultTextStyle>
  <p:extLst>
    <p:ext uri="{EFAFB233-063F-42B5-8137-9DF3F51BA10A}">
      <p15:sldGuideLst xmlns:p15="http://schemas.microsoft.com/office/powerpoint/2012/main">
        <p15:guide id="1" orient="horz" pos="2160">
          <p15:clr>
            <a:srgbClr val="A4A3A4"/>
          </p15:clr>
        </p15:guide>
        <p15:guide id="2" pos="312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lan naylor" initials="an" lastIdx="26"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0000FF"/>
    <a:srgbClr val="66FF33"/>
    <a:srgbClr val="009900"/>
    <a:srgbClr val="FF0000"/>
    <a:srgbClr val="003300"/>
    <a:srgbClr val="33CC33"/>
    <a:srgbClr val="CCECFF"/>
    <a:srgbClr val="99FF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2" d="100"/>
          <a:sy n="62" d="100"/>
        </p:scale>
        <p:origin x="1252" y="76"/>
      </p:cViewPr>
      <p:guideLst>
        <p:guide orient="horz" pos="2160"/>
        <p:guide pos="3120"/>
      </p:guideLst>
    </p:cSldViewPr>
  </p:slideViewPr>
  <p:notesTextViewPr>
    <p:cViewPr>
      <p:scale>
        <a:sx n="1" d="1"/>
        <a:sy n="1" d="1"/>
      </p:scale>
      <p:origin x="0" y="0"/>
    </p:cViewPr>
  </p:notesTextViewPr>
  <p:notesViewPr>
    <p:cSldViewPr snapToGrid="0">
      <p:cViewPr>
        <p:scale>
          <a:sx n="1" d="2"/>
          <a:sy n="1" d="2"/>
        </p:scale>
        <p:origin x="0" y="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notesMaster" Target="notesMasters/notesMaster1.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10" Type="http://schemas.microsoft.com/office/2016/11/relationships/changesInfo" Target="changesInfos/changesInfo1.xml"/><Relationship Id="rId4" Type="http://schemas.openxmlformats.org/officeDocument/2006/relationships/handoutMaster" Target="handoutMasters/handoutMaster1.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cNaughton, Peter" userId="9ee63666-e0f5-407d-845c-599ffbd0ff03" providerId="ADAL" clId="{37091426-AF10-44CF-91A1-7F3DB762328E}"/>
    <pc:docChg chg="delSld modSld delMainMaster">
      <pc:chgData name="McNaughton, Peter" userId="9ee63666-e0f5-407d-845c-599ffbd0ff03" providerId="ADAL" clId="{37091426-AF10-44CF-91A1-7F3DB762328E}" dt="2019-11-28T16:05:15.246" v="100" actId="1038"/>
      <pc:docMkLst>
        <pc:docMk/>
      </pc:docMkLst>
      <pc:sldChg chg="del">
        <pc:chgData name="McNaughton, Peter" userId="9ee63666-e0f5-407d-845c-599ffbd0ff03" providerId="ADAL" clId="{37091426-AF10-44CF-91A1-7F3DB762328E}" dt="2019-11-28T16:03:13.511" v="0" actId="2696"/>
        <pc:sldMkLst>
          <pc:docMk/>
          <pc:sldMk cId="0" sldId="256"/>
        </pc:sldMkLst>
      </pc:sldChg>
      <pc:sldChg chg="del">
        <pc:chgData name="McNaughton, Peter" userId="9ee63666-e0f5-407d-845c-599ffbd0ff03" providerId="ADAL" clId="{37091426-AF10-44CF-91A1-7F3DB762328E}" dt="2019-11-28T16:03:21.433" v="15" actId="2696"/>
        <pc:sldMkLst>
          <pc:docMk/>
          <pc:sldMk cId="1713579003" sldId="999"/>
        </pc:sldMkLst>
      </pc:sldChg>
      <pc:sldChg chg="del">
        <pc:chgData name="McNaughton, Peter" userId="9ee63666-e0f5-407d-845c-599ffbd0ff03" providerId="ADAL" clId="{37091426-AF10-44CF-91A1-7F3DB762328E}" dt="2019-11-28T16:03:13.559" v="3" actId="2696"/>
        <pc:sldMkLst>
          <pc:docMk/>
          <pc:sldMk cId="2039387847" sldId="1040"/>
        </pc:sldMkLst>
      </pc:sldChg>
      <pc:sldChg chg="del">
        <pc:chgData name="McNaughton, Peter" userId="9ee63666-e0f5-407d-845c-599ffbd0ff03" providerId="ADAL" clId="{37091426-AF10-44CF-91A1-7F3DB762328E}" dt="2019-11-28T16:03:13.527" v="1" actId="2696"/>
        <pc:sldMkLst>
          <pc:docMk/>
          <pc:sldMk cId="967794767" sldId="1043"/>
        </pc:sldMkLst>
      </pc:sldChg>
      <pc:sldChg chg="del">
        <pc:chgData name="McNaughton, Peter" userId="9ee63666-e0f5-407d-845c-599ffbd0ff03" providerId="ADAL" clId="{37091426-AF10-44CF-91A1-7F3DB762328E}" dt="2019-11-28T16:03:13.582" v="4" actId="2696"/>
        <pc:sldMkLst>
          <pc:docMk/>
          <pc:sldMk cId="1374863980" sldId="1047"/>
        </pc:sldMkLst>
      </pc:sldChg>
      <pc:sldChg chg="del">
        <pc:chgData name="McNaughton, Peter" userId="9ee63666-e0f5-407d-845c-599ffbd0ff03" providerId="ADAL" clId="{37091426-AF10-44CF-91A1-7F3DB762328E}" dt="2019-11-28T16:03:13.865" v="9" actId="2696"/>
        <pc:sldMkLst>
          <pc:docMk/>
          <pc:sldMk cId="1166270232" sldId="1061"/>
        </pc:sldMkLst>
      </pc:sldChg>
      <pc:sldChg chg="del">
        <pc:chgData name="McNaughton, Peter" userId="9ee63666-e0f5-407d-845c-599ffbd0ff03" providerId="ADAL" clId="{37091426-AF10-44CF-91A1-7F3DB762328E}" dt="2019-11-28T16:03:13.894" v="10" actId="2696"/>
        <pc:sldMkLst>
          <pc:docMk/>
          <pc:sldMk cId="3334218012" sldId="1062"/>
        </pc:sldMkLst>
      </pc:sldChg>
      <pc:sldChg chg="del">
        <pc:chgData name="McNaughton, Peter" userId="9ee63666-e0f5-407d-845c-599ffbd0ff03" providerId="ADAL" clId="{37091426-AF10-44CF-91A1-7F3DB762328E}" dt="2019-11-28T16:03:13.842" v="8" actId="2696"/>
        <pc:sldMkLst>
          <pc:docMk/>
          <pc:sldMk cId="4208915042" sldId="1063"/>
        </pc:sldMkLst>
      </pc:sldChg>
      <pc:sldChg chg="del">
        <pc:chgData name="McNaughton, Peter" userId="9ee63666-e0f5-407d-845c-599ffbd0ff03" providerId="ADAL" clId="{37091426-AF10-44CF-91A1-7F3DB762328E}" dt="2019-11-28T16:03:13.799" v="7" actId="2696"/>
        <pc:sldMkLst>
          <pc:docMk/>
          <pc:sldMk cId="3818966307" sldId="1064"/>
        </pc:sldMkLst>
      </pc:sldChg>
      <pc:sldChg chg="del">
        <pc:chgData name="McNaughton, Peter" userId="9ee63666-e0f5-407d-845c-599ffbd0ff03" providerId="ADAL" clId="{37091426-AF10-44CF-91A1-7F3DB762328E}" dt="2019-11-28T16:03:13.586" v="5" actId="2696"/>
        <pc:sldMkLst>
          <pc:docMk/>
          <pc:sldMk cId="3467134952" sldId="1065"/>
        </pc:sldMkLst>
      </pc:sldChg>
      <pc:sldChg chg="del">
        <pc:chgData name="McNaughton, Peter" userId="9ee63666-e0f5-407d-845c-599ffbd0ff03" providerId="ADAL" clId="{37091426-AF10-44CF-91A1-7F3DB762328E}" dt="2019-11-28T16:03:13.667" v="6" actId="2696"/>
        <pc:sldMkLst>
          <pc:docMk/>
          <pc:sldMk cId="1045846588" sldId="1066"/>
        </pc:sldMkLst>
      </pc:sldChg>
      <pc:sldChg chg="modSp">
        <pc:chgData name="McNaughton, Peter" userId="9ee63666-e0f5-407d-845c-599ffbd0ff03" providerId="ADAL" clId="{37091426-AF10-44CF-91A1-7F3DB762328E}" dt="2019-11-28T16:05:15.246" v="100" actId="1038"/>
        <pc:sldMkLst>
          <pc:docMk/>
          <pc:sldMk cId="879679908" sldId="1067"/>
        </pc:sldMkLst>
        <pc:spChg chg="mod">
          <ac:chgData name="McNaughton, Peter" userId="9ee63666-e0f5-407d-845c-599ffbd0ff03" providerId="ADAL" clId="{37091426-AF10-44CF-91A1-7F3DB762328E}" dt="2019-11-28T16:05:06.811" v="79" actId="1076"/>
          <ac:spMkLst>
            <pc:docMk/>
            <pc:sldMk cId="879679908" sldId="1067"/>
            <ac:spMk id="3" creationId="{33C9DBC5-339C-4CB5-BEF5-5B80D2697E1F}"/>
          </ac:spMkLst>
        </pc:spChg>
        <pc:picChg chg="mod">
          <ac:chgData name="McNaughton, Peter" userId="9ee63666-e0f5-407d-845c-599ffbd0ff03" providerId="ADAL" clId="{37091426-AF10-44CF-91A1-7F3DB762328E}" dt="2019-11-28T16:05:15.246" v="100" actId="1038"/>
          <ac:picMkLst>
            <pc:docMk/>
            <pc:sldMk cId="879679908" sldId="1067"/>
            <ac:picMk id="2" creationId="{57959641-B2B4-4B71-A295-5D1E5D7C3C78}"/>
          </ac:picMkLst>
        </pc:picChg>
      </pc:sldChg>
      <pc:sldChg chg="del">
        <pc:chgData name="McNaughton, Peter" userId="9ee63666-e0f5-407d-845c-599ffbd0ff03" providerId="ADAL" clId="{37091426-AF10-44CF-91A1-7F3DB762328E}" dt="2019-11-28T16:03:21.402" v="13" actId="2696"/>
        <pc:sldMkLst>
          <pc:docMk/>
          <pc:sldMk cId="4091570391" sldId="1068"/>
        </pc:sldMkLst>
      </pc:sldChg>
      <pc:sldChg chg="del">
        <pc:chgData name="McNaughton, Peter" userId="9ee63666-e0f5-407d-845c-599ffbd0ff03" providerId="ADAL" clId="{37091426-AF10-44CF-91A1-7F3DB762328E}" dt="2019-11-28T16:03:21.427" v="14" actId="2696"/>
        <pc:sldMkLst>
          <pc:docMk/>
          <pc:sldMk cId="1505953833" sldId="1069"/>
        </pc:sldMkLst>
      </pc:sldChg>
      <pc:sldChg chg="del">
        <pc:chgData name="McNaughton, Peter" userId="9ee63666-e0f5-407d-845c-599ffbd0ff03" providerId="ADAL" clId="{37091426-AF10-44CF-91A1-7F3DB762328E}" dt="2019-11-28T16:03:13.550" v="2" actId="2696"/>
        <pc:sldMkLst>
          <pc:docMk/>
          <pc:sldMk cId="1315797268" sldId="1070"/>
        </pc:sldMkLst>
      </pc:sldChg>
      <pc:sldChg chg="del">
        <pc:chgData name="McNaughton, Peter" userId="9ee63666-e0f5-407d-845c-599ffbd0ff03" providerId="ADAL" clId="{37091426-AF10-44CF-91A1-7F3DB762328E}" dt="2019-11-28T16:03:13.920" v="12" actId="2696"/>
        <pc:sldMkLst>
          <pc:docMk/>
          <pc:sldMk cId="758208007" sldId="1071"/>
        </pc:sldMkLst>
      </pc:sldChg>
      <pc:sldChg chg="del">
        <pc:chgData name="McNaughton, Peter" userId="9ee63666-e0f5-407d-845c-599ffbd0ff03" providerId="ADAL" clId="{37091426-AF10-44CF-91A1-7F3DB762328E}" dt="2019-11-28T16:03:13.902" v="11" actId="2696"/>
        <pc:sldMkLst>
          <pc:docMk/>
          <pc:sldMk cId="804174262" sldId="1072"/>
        </pc:sldMkLst>
      </pc:sldChg>
      <pc:sldMasterChg chg="del delSldLayout">
        <pc:chgData name="McNaughton, Peter" userId="9ee63666-e0f5-407d-845c-599ffbd0ff03" providerId="ADAL" clId="{37091426-AF10-44CF-91A1-7F3DB762328E}" dt="2019-11-28T16:03:21.472" v="29" actId="2696"/>
        <pc:sldMasterMkLst>
          <pc:docMk/>
          <pc:sldMasterMk cId="3617604604" sldId="2147483789"/>
        </pc:sldMasterMkLst>
        <pc:sldLayoutChg chg="del">
          <pc:chgData name="McNaughton, Peter" userId="9ee63666-e0f5-407d-845c-599ffbd0ff03" providerId="ADAL" clId="{37091426-AF10-44CF-91A1-7F3DB762328E}" dt="2019-11-28T16:03:21.450" v="16" actId="2696"/>
          <pc:sldLayoutMkLst>
            <pc:docMk/>
            <pc:sldMasterMk cId="3617604604" sldId="2147483789"/>
            <pc:sldLayoutMk cId="1695314910" sldId="2147483790"/>
          </pc:sldLayoutMkLst>
        </pc:sldLayoutChg>
        <pc:sldLayoutChg chg="del">
          <pc:chgData name="McNaughton, Peter" userId="9ee63666-e0f5-407d-845c-599ffbd0ff03" providerId="ADAL" clId="{37091426-AF10-44CF-91A1-7F3DB762328E}" dt="2019-11-28T16:03:21.456" v="17" actId="2696"/>
          <pc:sldLayoutMkLst>
            <pc:docMk/>
            <pc:sldMasterMk cId="3617604604" sldId="2147483789"/>
            <pc:sldLayoutMk cId="1930703135" sldId="2147483791"/>
          </pc:sldLayoutMkLst>
        </pc:sldLayoutChg>
        <pc:sldLayoutChg chg="del">
          <pc:chgData name="McNaughton, Peter" userId="9ee63666-e0f5-407d-845c-599ffbd0ff03" providerId="ADAL" clId="{37091426-AF10-44CF-91A1-7F3DB762328E}" dt="2019-11-28T16:03:21.458" v="18" actId="2696"/>
          <pc:sldLayoutMkLst>
            <pc:docMk/>
            <pc:sldMasterMk cId="3617604604" sldId="2147483789"/>
            <pc:sldLayoutMk cId="1880460035" sldId="2147483792"/>
          </pc:sldLayoutMkLst>
        </pc:sldLayoutChg>
        <pc:sldLayoutChg chg="del">
          <pc:chgData name="McNaughton, Peter" userId="9ee63666-e0f5-407d-845c-599ffbd0ff03" providerId="ADAL" clId="{37091426-AF10-44CF-91A1-7F3DB762328E}" dt="2019-11-28T16:03:21.459" v="19" actId="2696"/>
          <pc:sldLayoutMkLst>
            <pc:docMk/>
            <pc:sldMasterMk cId="3617604604" sldId="2147483789"/>
            <pc:sldLayoutMk cId="1012616528" sldId="2147483793"/>
          </pc:sldLayoutMkLst>
        </pc:sldLayoutChg>
        <pc:sldLayoutChg chg="del">
          <pc:chgData name="McNaughton, Peter" userId="9ee63666-e0f5-407d-845c-599ffbd0ff03" providerId="ADAL" clId="{37091426-AF10-44CF-91A1-7F3DB762328E}" dt="2019-11-28T16:03:21.460" v="20" actId="2696"/>
          <pc:sldLayoutMkLst>
            <pc:docMk/>
            <pc:sldMasterMk cId="3617604604" sldId="2147483789"/>
            <pc:sldLayoutMk cId="227034768" sldId="2147483794"/>
          </pc:sldLayoutMkLst>
        </pc:sldLayoutChg>
        <pc:sldLayoutChg chg="del">
          <pc:chgData name="McNaughton, Peter" userId="9ee63666-e0f5-407d-845c-599ffbd0ff03" providerId="ADAL" clId="{37091426-AF10-44CF-91A1-7F3DB762328E}" dt="2019-11-28T16:03:21.461" v="21" actId="2696"/>
          <pc:sldLayoutMkLst>
            <pc:docMk/>
            <pc:sldMasterMk cId="3617604604" sldId="2147483789"/>
            <pc:sldLayoutMk cId="394535753" sldId="2147483795"/>
          </pc:sldLayoutMkLst>
        </pc:sldLayoutChg>
        <pc:sldLayoutChg chg="del">
          <pc:chgData name="McNaughton, Peter" userId="9ee63666-e0f5-407d-845c-599ffbd0ff03" providerId="ADAL" clId="{37091426-AF10-44CF-91A1-7F3DB762328E}" dt="2019-11-28T16:03:21.463" v="22" actId="2696"/>
          <pc:sldLayoutMkLst>
            <pc:docMk/>
            <pc:sldMasterMk cId="3617604604" sldId="2147483789"/>
            <pc:sldLayoutMk cId="3339577303" sldId="2147483796"/>
          </pc:sldLayoutMkLst>
        </pc:sldLayoutChg>
        <pc:sldLayoutChg chg="del">
          <pc:chgData name="McNaughton, Peter" userId="9ee63666-e0f5-407d-845c-599ffbd0ff03" providerId="ADAL" clId="{37091426-AF10-44CF-91A1-7F3DB762328E}" dt="2019-11-28T16:03:21.464" v="23" actId="2696"/>
          <pc:sldLayoutMkLst>
            <pc:docMk/>
            <pc:sldMasterMk cId="3617604604" sldId="2147483789"/>
            <pc:sldLayoutMk cId="2853890688" sldId="2147483797"/>
          </pc:sldLayoutMkLst>
        </pc:sldLayoutChg>
        <pc:sldLayoutChg chg="del">
          <pc:chgData name="McNaughton, Peter" userId="9ee63666-e0f5-407d-845c-599ffbd0ff03" providerId="ADAL" clId="{37091426-AF10-44CF-91A1-7F3DB762328E}" dt="2019-11-28T16:03:21.466" v="24" actId="2696"/>
          <pc:sldLayoutMkLst>
            <pc:docMk/>
            <pc:sldMasterMk cId="3617604604" sldId="2147483789"/>
            <pc:sldLayoutMk cId="978468639" sldId="2147483798"/>
          </pc:sldLayoutMkLst>
        </pc:sldLayoutChg>
        <pc:sldLayoutChg chg="del">
          <pc:chgData name="McNaughton, Peter" userId="9ee63666-e0f5-407d-845c-599ffbd0ff03" providerId="ADAL" clId="{37091426-AF10-44CF-91A1-7F3DB762328E}" dt="2019-11-28T16:03:21.467" v="25" actId="2696"/>
          <pc:sldLayoutMkLst>
            <pc:docMk/>
            <pc:sldMasterMk cId="3617604604" sldId="2147483789"/>
            <pc:sldLayoutMk cId="4002300719" sldId="2147483799"/>
          </pc:sldLayoutMkLst>
        </pc:sldLayoutChg>
        <pc:sldLayoutChg chg="del">
          <pc:chgData name="McNaughton, Peter" userId="9ee63666-e0f5-407d-845c-599ffbd0ff03" providerId="ADAL" clId="{37091426-AF10-44CF-91A1-7F3DB762328E}" dt="2019-11-28T16:03:21.468" v="26" actId="2696"/>
          <pc:sldLayoutMkLst>
            <pc:docMk/>
            <pc:sldMasterMk cId="3617604604" sldId="2147483789"/>
            <pc:sldLayoutMk cId="1149594931" sldId="2147483800"/>
          </pc:sldLayoutMkLst>
        </pc:sldLayoutChg>
        <pc:sldLayoutChg chg="del">
          <pc:chgData name="McNaughton, Peter" userId="9ee63666-e0f5-407d-845c-599ffbd0ff03" providerId="ADAL" clId="{37091426-AF10-44CF-91A1-7F3DB762328E}" dt="2019-11-28T16:03:21.469" v="27" actId="2696"/>
          <pc:sldLayoutMkLst>
            <pc:docMk/>
            <pc:sldMasterMk cId="3617604604" sldId="2147483789"/>
            <pc:sldLayoutMk cId="2230763404" sldId="2147483801"/>
          </pc:sldLayoutMkLst>
        </pc:sldLayoutChg>
        <pc:sldLayoutChg chg="del">
          <pc:chgData name="McNaughton, Peter" userId="9ee63666-e0f5-407d-845c-599ffbd0ff03" providerId="ADAL" clId="{37091426-AF10-44CF-91A1-7F3DB762328E}" dt="2019-11-28T16:03:21.470" v="28" actId="2696"/>
          <pc:sldLayoutMkLst>
            <pc:docMk/>
            <pc:sldMasterMk cId="3617604604" sldId="2147483789"/>
            <pc:sldLayoutMk cId="1094355191" sldId="2147483802"/>
          </pc:sldLayoutMkLst>
        </pc:sldLayoutChg>
      </pc:sldMasterChg>
    </pc:docChg>
  </pc:docChgLst>
  <pc:docChgLst>
    <pc:chgData name="McNaughton, Peter" userId="9ee63666-e0f5-407d-845c-599ffbd0ff03" providerId="ADAL" clId="{F728779B-3A18-4A15-A1D4-F744804801C5}"/>
    <pc:docChg chg="undo custSel addSld delSld modSld sldOrd">
      <pc:chgData name="McNaughton, Peter" userId="9ee63666-e0f5-407d-845c-599ffbd0ff03" providerId="ADAL" clId="{F728779B-3A18-4A15-A1D4-F744804801C5}" dt="2019-07-29T13:10:22.764" v="1694" actId="20577"/>
      <pc:docMkLst>
        <pc:docMk/>
      </pc:docMkLst>
      <pc:sldChg chg="modSp">
        <pc:chgData name="McNaughton, Peter" userId="9ee63666-e0f5-407d-845c-599ffbd0ff03" providerId="ADAL" clId="{F728779B-3A18-4A15-A1D4-F744804801C5}" dt="2019-07-25T14:59:11.907" v="561" actId="20577"/>
        <pc:sldMkLst>
          <pc:docMk/>
          <pc:sldMk cId="0" sldId="256"/>
        </pc:sldMkLst>
        <pc:spChg chg="mod">
          <ac:chgData name="McNaughton, Peter" userId="9ee63666-e0f5-407d-845c-599ffbd0ff03" providerId="ADAL" clId="{F728779B-3A18-4A15-A1D4-F744804801C5}" dt="2019-07-25T14:58:57.817" v="549" actId="20577"/>
          <ac:spMkLst>
            <pc:docMk/>
            <pc:sldMk cId="0" sldId="256"/>
            <ac:spMk id="2050" creationId="{00000000-0000-0000-0000-000000000000}"/>
          </ac:spMkLst>
        </pc:spChg>
        <pc:spChg chg="mod">
          <ac:chgData name="McNaughton, Peter" userId="9ee63666-e0f5-407d-845c-599ffbd0ff03" providerId="ADAL" clId="{F728779B-3A18-4A15-A1D4-F744804801C5}" dt="2019-07-25T14:59:11.907" v="561" actId="20577"/>
          <ac:spMkLst>
            <pc:docMk/>
            <pc:sldMk cId="0" sldId="256"/>
            <ac:spMk id="2053" creationId="{00000000-0000-0000-0000-000000000000}"/>
          </ac:spMkLst>
        </pc:spChg>
      </pc:sldChg>
      <pc:sldChg chg="modSp">
        <pc:chgData name="McNaughton, Peter" userId="9ee63666-e0f5-407d-845c-599ffbd0ff03" providerId="ADAL" clId="{F728779B-3A18-4A15-A1D4-F744804801C5}" dt="2019-07-25T14:59:41.062" v="580" actId="1076"/>
        <pc:sldMkLst>
          <pc:docMk/>
          <pc:sldMk cId="2039387847" sldId="1040"/>
        </pc:sldMkLst>
        <pc:spChg chg="mod">
          <ac:chgData name="McNaughton, Peter" userId="9ee63666-e0f5-407d-845c-599ffbd0ff03" providerId="ADAL" clId="{F728779B-3A18-4A15-A1D4-F744804801C5}" dt="2019-07-25T14:59:41.062" v="580" actId="1076"/>
          <ac:spMkLst>
            <pc:docMk/>
            <pc:sldMk cId="2039387847" sldId="1040"/>
            <ac:spMk id="2" creationId="{3DAB31B9-A013-4822-9FA4-2455BA7A3ABA}"/>
          </ac:spMkLst>
        </pc:spChg>
      </pc:sldChg>
      <pc:sldChg chg="addSp delSp modSp ord">
        <pc:chgData name="McNaughton, Peter" userId="9ee63666-e0f5-407d-845c-599ffbd0ff03" providerId="ADAL" clId="{F728779B-3A18-4A15-A1D4-F744804801C5}" dt="2019-07-25T17:04:20.330" v="961" actId="1036"/>
        <pc:sldMkLst>
          <pc:docMk/>
          <pc:sldMk cId="967794767" sldId="1043"/>
        </pc:sldMkLst>
        <pc:spChg chg="add mod">
          <ac:chgData name="McNaughton, Peter" userId="9ee63666-e0f5-407d-845c-599ffbd0ff03" providerId="ADAL" clId="{F728779B-3A18-4A15-A1D4-F744804801C5}" dt="2019-07-25T17:04:00.873" v="945" actId="1035"/>
          <ac:spMkLst>
            <pc:docMk/>
            <pc:sldMk cId="967794767" sldId="1043"/>
            <ac:spMk id="7" creationId="{76AF923D-B7A6-4611-A63B-92181EDF3954}"/>
          </ac:spMkLst>
        </pc:spChg>
        <pc:spChg chg="add mod">
          <ac:chgData name="McNaughton, Peter" userId="9ee63666-e0f5-407d-845c-599ffbd0ff03" providerId="ADAL" clId="{F728779B-3A18-4A15-A1D4-F744804801C5}" dt="2019-07-25T17:04:11.274" v="952" actId="1036"/>
          <ac:spMkLst>
            <pc:docMk/>
            <pc:sldMk cId="967794767" sldId="1043"/>
            <ac:spMk id="8" creationId="{C2B0084E-10E9-411C-8FE5-1E282B49D570}"/>
          </ac:spMkLst>
        </pc:spChg>
        <pc:spChg chg="add mod">
          <ac:chgData name="McNaughton, Peter" userId="9ee63666-e0f5-407d-845c-599ffbd0ff03" providerId="ADAL" clId="{F728779B-3A18-4A15-A1D4-F744804801C5}" dt="2019-07-25T17:04:20.330" v="961" actId="1036"/>
          <ac:spMkLst>
            <pc:docMk/>
            <pc:sldMk cId="967794767" sldId="1043"/>
            <ac:spMk id="9" creationId="{00E223E9-7CCB-4391-AC28-6A0F20ABDFB2}"/>
          </ac:spMkLst>
        </pc:spChg>
        <pc:grpChg chg="add mod">
          <ac:chgData name="McNaughton, Peter" userId="9ee63666-e0f5-407d-845c-599ffbd0ff03" providerId="ADAL" clId="{F728779B-3A18-4A15-A1D4-F744804801C5}" dt="2019-07-25T17:03:45.943" v="937" actId="1076"/>
          <ac:grpSpMkLst>
            <pc:docMk/>
            <pc:sldMk cId="967794767" sldId="1043"/>
            <ac:grpSpMk id="10" creationId="{EE02C8A7-9D8C-4E2A-93E6-527767A59204}"/>
          </ac:grpSpMkLst>
        </pc:grpChg>
        <pc:picChg chg="del">
          <ac:chgData name="McNaughton, Peter" userId="9ee63666-e0f5-407d-845c-599ffbd0ff03" providerId="ADAL" clId="{F728779B-3A18-4A15-A1D4-F744804801C5}" dt="2019-07-25T17:03:25.914" v="933" actId="478"/>
          <ac:picMkLst>
            <pc:docMk/>
            <pc:sldMk cId="967794767" sldId="1043"/>
            <ac:picMk id="2" creationId="{AC97E413-D080-4CAF-9CFA-B7D06A7DF0AD}"/>
          </ac:picMkLst>
        </pc:picChg>
        <pc:picChg chg="add mod">
          <ac:chgData name="McNaughton, Peter" userId="9ee63666-e0f5-407d-845c-599ffbd0ff03" providerId="ADAL" clId="{F728779B-3A18-4A15-A1D4-F744804801C5}" dt="2019-07-25T17:03:37.236" v="935" actId="164"/>
          <ac:picMkLst>
            <pc:docMk/>
            <pc:sldMk cId="967794767" sldId="1043"/>
            <ac:picMk id="4" creationId="{603C3AA1-9446-49C4-9A11-9024610CE71B}"/>
          </ac:picMkLst>
        </pc:picChg>
        <pc:picChg chg="add mod">
          <ac:chgData name="McNaughton, Peter" userId="9ee63666-e0f5-407d-845c-599ffbd0ff03" providerId="ADAL" clId="{F728779B-3A18-4A15-A1D4-F744804801C5}" dt="2019-07-25T17:03:37.236" v="935" actId="164"/>
          <ac:picMkLst>
            <pc:docMk/>
            <pc:sldMk cId="967794767" sldId="1043"/>
            <ac:picMk id="5" creationId="{517951BB-66A3-4403-BAF2-322F2900D462}"/>
          </ac:picMkLst>
        </pc:picChg>
        <pc:picChg chg="add mod">
          <ac:chgData name="McNaughton, Peter" userId="9ee63666-e0f5-407d-845c-599ffbd0ff03" providerId="ADAL" clId="{F728779B-3A18-4A15-A1D4-F744804801C5}" dt="2019-07-25T17:03:37.236" v="935" actId="164"/>
          <ac:picMkLst>
            <pc:docMk/>
            <pc:sldMk cId="967794767" sldId="1043"/>
            <ac:picMk id="6" creationId="{5F4CC09C-A765-4248-B9DA-91677ADACE04}"/>
          </ac:picMkLst>
        </pc:picChg>
      </pc:sldChg>
      <pc:sldChg chg="addSp delSp modSp">
        <pc:chgData name="McNaughton, Peter" userId="9ee63666-e0f5-407d-845c-599ffbd0ff03" providerId="ADAL" clId="{F728779B-3A18-4A15-A1D4-F744804801C5}" dt="2019-07-25T16:56:44.794" v="921"/>
        <pc:sldMkLst>
          <pc:docMk/>
          <pc:sldMk cId="1374863980" sldId="1047"/>
        </pc:sldMkLst>
        <pc:spChg chg="mod">
          <ac:chgData name="McNaughton, Peter" userId="9ee63666-e0f5-407d-845c-599ffbd0ff03" providerId="ADAL" clId="{F728779B-3A18-4A15-A1D4-F744804801C5}" dt="2019-07-25T16:56:34.853" v="919" actId="1076"/>
          <ac:spMkLst>
            <pc:docMk/>
            <pc:sldMk cId="1374863980" sldId="1047"/>
            <ac:spMk id="3" creationId="{AFB259BA-0AA8-406E-92F4-24DC427437C3}"/>
          </ac:spMkLst>
        </pc:spChg>
        <pc:spChg chg="mod">
          <ac:chgData name="McNaughton, Peter" userId="9ee63666-e0f5-407d-845c-599ffbd0ff03" providerId="ADAL" clId="{F728779B-3A18-4A15-A1D4-F744804801C5}" dt="2019-07-24T17:57:13.516" v="490" actId="6549"/>
          <ac:spMkLst>
            <pc:docMk/>
            <pc:sldMk cId="1374863980" sldId="1047"/>
            <ac:spMk id="6" creationId="{5216D589-490D-4EAF-9CA8-F73ABD20E0EB}"/>
          </ac:spMkLst>
        </pc:spChg>
        <pc:spChg chg="add mod">
          <ac:chgData name="McNaughton, Peter" userId="9ee63666-e0f5-407d-845c-599ffbd0ff03" providerId="ADAL" clId="{F728779B-3A18-4A15-A1D4-F744804801C5}" dt="2019-07-25T15:48:46.392" v="768" actId="1076"/>
          <ac:spMkLst>
            <pc:docMk/>
            <pc:sldMk cId="1374863980" sldId="1047"/>
            <ac:spMk id="7" creationId="{84070474-163C-48F2-A3C2-BBBDA4D440B5}"/>
          </ac:spMkLst>
        </pc:spChg>
        <pc:spChg chg="add del">
          <ac:chgData name="McNaughton, Peter" userId="9ee63666-e0f5-407d-845c-599ffbd0ff03" providerId="ADAL" clId="{F728779B-3A18-4A15-A1D4-F744804801C5}" dt="2019-07-25T16:56:44.794" v="921"/>
          <ac:spMkLst>
            <pc:docMk/>
            <pc:sldMk cId="1374863980" sldId="1047"/>
            <ac:spMk id="8" creationId="{A97D75AE-0322-435F-9272-151FB99AA837}"/>
          </ac:spMkLst>
        </pc:spChg>
        <pc:spChg chg="add mod">
          <ac:chgData name="McNaughton, Peter" userId="9ee63666-e0f5-407d-845c-599ffbd0ff03" providerId="ADAL" clId="{F728779B-3A18-4A15-A1D4-F744804801C5}" dt="2019-07-25T15:48:04.626" v="715" actId="1076"/>
          <ac:spMkLst>
            <pc:docMk/>
            <pc:sldMk cId="1374863980" sldId="1047"/>
            <ac:spMk id="11" creationId="{27BD67CF-4A2D-4509-8E34-FF448E2E2258}"/>
          </ac:spMkLst>
        </pc:spChg>
        <pc:grpChg chg="del">
          <ac:chgData name="McNaughton, Peter" userId="9ee63666-e0f5-407d-845c-599ffbd0ff03" providerId="ADAL" clId="{F728779B-3A18-4A15-A1D4-F744804801C5}" dt="2019-07-24T17:46:52.627" v="232"/>
          <ac:grpSpMkLst>
            <pc:docMk/>
            <pc:sldMk cId="1374863980" sldId="1047"/>
            <ac:grpSpMk id="5" creationId="{3426F6D6-77B6-4FE0-A2D1-AF7870CD6439}"/>
          </ac:grpSpMkLst>
        </pc:grpChg>
        <pc:grpChg chg="add del mod">
          <ac:chgData name="McNaughton, Peter" userId="9ee63666-e0f5-407d-845c-599ffbd0ff03" providerId="ADAL" clId="{F728779B-3A18-4A15-A1D4-F744804801C5}" dt="2019-07-24T17:47:27.089" v="236"/>
          <ac:grpSpMkLst>
            <pc:docMk/>
            <pc:sldMk cId="1374863980" sldId="1047"/>
            <ac:grpSpMk id="10" creationId="{E7A8DC88-1AE9-4A03-AC15-42FD3DF6E5D2}"/>
          </ac:grpSpMkLst>
        </pc:grpChg>
        <pc:picChg chg="mod">
          <ac:chgData name="McNaughton, Peter" userId="9ee63666-e0f5-407d-845c-599ffbd0ff03" providerId="ADAL" clId="{F728779B-3A18-4A15-A1D4-F744804801C5}" dt="2019-07-24T17:47:17.323" v="234" actId="164"/>
          <ac:picMkLst>
            <pc:docMk/>
            <pc:sldMk cId="1374863980" sldId="1047"/>
            <ac:picMk id="7" creationId="{42EEDC5F-E057-46F6-9CE7-174AD15865A8}"/>
          </ac:picMkLst>
        </pc:picChg>
        <pc:picChg chg="mod">
          <ac:chgData name="McNaughton, Peter" userId="9ee63666-e0f5-407d-845c-599ffbd0ff03" providerId="ADAL" clId="{F728779B-3A18-4A15-A1D4-F744804801C5}" dt="2019-07-24T17:47:17.323" v="234" actId="164"/>
          <ac:picMkLst>
            <pc:docMk/>
            <pc:sldMk cId="1374863980" sldId="1047"/>
            <ac:picMk id="8" creationId="{3A79D639-DE43-4CB6-B3D2-1C3297AA58BB}"/>
          </ac:picMkLst>
        </pc:picChg>
        <pc:picChg chg="mod">
          <ac:chgData name="McNaughton, Peter" userId="9ee63666-e0f5-407d-845c-599ffbd0ff03" providerId="ADAL" clId="{F728779B-3A18-4A15-A1D4-F744804801C5}" dt="2019-07-24T17:47:22.249" v="235" actId="1076"/>
          <ac:picMkLst>
            <pc:docMk/>
            <pc:sldMk cId="1374863980" sldId="1047"/>
            <ac:picMk id="9" creationId="{09232AA0-59C3-466C-B3B8-3FD7273C4AD2}"/>
          </ac:picMkLst>
        </pc:picChg>
        <pc:picChg chg="add mod">
          <ac:chgData name="McNaughton, Peter" userId="9ee63666-e0f5-407d-845c-599ffbd0ff03" providerId="ADAL" clId="{F728779B-3A18-4A15-A1D4-F744804801C5}" dt="2019-07-24T17:58:03.580" v="495" actId="1076"/>
          <ac:picMkLst>
            <pc:docMk/>
            <pc:sldMk cId="1374863980" sldId="1047"/>
            <ac:picMk id="12" creationId="{D7488D19-C6E3-4908-9D95-CA629712B70F}"/>
          </ac:picMkLst>
        </pc:picChg>
      </pc:sldChg>
      <pc:sldChg chg="addSp modSp add ord">
        <pc:chgData name="McNaughton, Peter" userId="9ee63666-e0f5-407d-845c-599ffbd0ff03" providerId="ADAL" clId="{F728779B-3A18-4A15-A1D4-F744804801C5}" dt="2019-07-25T16:54:53.586" v="915"/>
        <pc:sldMkLst>
          <pc:docMk/>
          <pc:sldMk cId="1166270232" sldId="1061"/>
        </pc:sldMkLst>
        <pc:spChg chg="add mod">
          <ac:chgData name="McNaughton, Peter" userId="9ee63666-e0f5-407d-845c-599ffbd0ff03" providerId="ADAL" clId="{F728779B-3A18-4A15-A1D4-F744804801C5}" dt="2019-07-24T17:46:28.997" v="230" actId="1076"/>
          <ac:spMkLst>
            <pc:docMk/>
            <pc:sldMk cId="1166270232" sldId="1061"/>
            <ac:spMk id="5" creationId="{003F7EB9-5822-4FA9-9145-C1BDD5E937F1}"/>
          </ac:spMkLst>
        </pc:spChg>
        <pc:picChg chg="add mod">
          <ac:chgData name="McNaughton, Peter" userId="9ee63666-e0f5-407d-845c-599ffbd0ff03" providerId="ADAL" clId="{F728779B-3A18-4A15-A1D4-F744804801C5}" dt="2019-07-24T17:46:23.818" v="228" actId="1076"/>
          <ac:picMkLst>
            <pc:docMk/>
            <pc:sldMk cId="1166270232" sldId="1061"/>
            <ac:picMk id="2" creationId="{9F047757-925E-4699-A36D-29AA5525E5BF}"/>
          </ac:picMkLst>
        </pc:picChg>
        <pc:picChg chg="add mod">
          <ac:chgData name="McNaughton, Peter" userId="9ee63666-e0f5-407d-845c-599ffbd0ff03" providerId="ADAL" clId="{F728779B-3A18-4A15-A1D4-F744804801C5}" dt="2019-07-25T15:00:21.136" v="581" actId="1076"/>
          <ac:picMkLst>
            <pc:docMk/>
            <pc:sldMk cId="1166270232" sldId="1061"/>
            <ac:picMk id="3" creationId="{E51EC766-22F1-46DA-A21C-2D43C5CDC7CE}"/>
          </ac:picMkLst>
        </pc:picChg>
        <pc:picChg chg="add mod">
          <ac:chgData name="McNaughton, Peter" userId="9ee63666-e0f5-407d-845c-599ffbd0ff03" providerId="ADAL" clId="{F728779B-3A18-4A15-A1D4-F744804801C5}" dt="2019-07-24T17:46:20.726" v="227" actId="1076"/>
          <ac:picMkLst>
            <pc:docMk/>
            <pc:sldMk cId="1166270232" sldId="1061"/>
            <ac:picMk id="4" creationId="{020E46D6-1650-4EF6-B070-A75B61F94DCE}"/>
          </ac:picMkLst>
        </pc:picChg>
      </pc:sldChg>
      <pc:sldChg chg="addSp modSp add ord">
        <pc:chgData name="McNaughton, Peter" userId="9ee63666-e0f5-407d-845c-599ffbd0ff03" providerId="ADAL" clId="{F728779B-3A18-4A15-A1D4-F744804801C5}" dt="2019-07-25T16:54:53.586" v="915"/>
        <pc:sldMkLst>
          <pc:docMk/>
          <pc:sldMk cId="3334218012" sldId="1062"/>
        </pc:sldMkLst>
        <pc:spChg chg="add mod">
          <ac:chgData name="McNaughton, Peter" userId="9ee63666-e0f5-407d-845c-599ffbd0ff03" providerId="ADAL" clId="{F728779B-3A18-4A15-A1D4-F744804801C5}" dt="2019-07-24T17:45:36.248" v="225" actId="20577"/>
          <ac:spMkLst>
            <pc:docMk/>
            <pc:sldMk cId="3334218012" sldId="1062"/>
            <ac:spMk id="8" creationId="{30ED358C-EB0F-4B85-A413-BD9AAD9C19B4}"/>
          </ac:spMkLst>
        </pc:spChg>
        <pc:grpChg chg="add mod">
          <ac:chgData name="McNaughton, Peter" userId="9ee63666-e0f5-407d-845c-599ffbd0ff03" providerId="ADAL" clId="{F728779B-3A18-4A15-A1D4-F744804801C5}" dt="2019-07-24T17:31:15.488" v="94" actId="1076"/>
          <ac:grpSpMkLst>
            <pc:docMk/>
            <pc:sldMk cId="3334218012" sldId="1062"/>
            <ac:grpSpMk id="2" creationId="{3F76C47A-7AB9-41BC-AD21-031F4C2405F1}"/>
          </ac:grpSpMkLst>
        </pc:grpChg>
        <pc:picChg chg="add mod">
          <ac:chgData name="McNaughton, Peter" userId="9ee63666-e0f5-407d-845c-599ffbd0ff03" providerId="ADAL" clId="{F728779B-3A18-4A15-A1D4-F744804801C5}" dt="2019-07-24T17:37:25.903" v="98" actId="1076"/>
          <ac:picMkLst>
            <pc:docMk/>
            <pc:sldMk cId="3334218012" sldId="1062"/>
            <ac:picMk id="5" creationId="{23EE0E07-4AB9-4B5D-B21E-B7921C32F3FC}"/>
          </ac:picMkLst>
        </pc:picChg>
        <pc:picChg chg="add mod">
          <ac:chgData name="McNaughton, Peter" userId="9ee63666-e0f5-407d-845c-599ffbd0ff03" providerId="ADAL" clId="{F728779B-3A18-4A15-A1D4-F744804801C5}" dt="2019-07-24T17:37:56.326" v="101" actId="1076"/>
          <ac:picMkLst>
            <pc:docMk/>
            <pc:sldMk cId="3334218012" sldId="1062"/>
            <ac:picMk id="6" creationId="{EDAC5327-3E00-4548-B876-D7F759324E19}"/>
          </ac:picMkLst>
        </pc:picChg>
        <pc:picChg chg="add mod">
          <ac:chgData name="McNaughton, Peter" userId="9ee63666-e0f5-407d-845c-599ffbd0ff03" providerId="ADAL" clId="{F728779B-3A18-4A15-A1D4-F744804801C5}" dt="2019-07-24T17:40:25.114" v="105" actId="1076"/>
          <ac:picMkLst>
            <pc:docMk/>
            <pc:sldMk cId="3334218012" sldId="1062"/>
            <ac:picMk id="7" creationId="{950B4683-4CE0-4670-A56B-4F436CB5EFFA}"/>
          </ac:picMkLst>
        </pc:picChg>
      </pc:sldChg>
      <pc:sldChg chg="addSp modSp add">
        <pc:chgData name="McNaughton, Peter" userId="9ee63666-e0f5-407d-845c-599ffbd0ff03" providerId="ADAL" clId="{F728779B-3A18-4A15-A1D4-F744804801C5}" dt="2019-07-25T16:52:25.340" v="914" actId="14100"/>
        <pc:sldMkLst>
          <pc:docMk/>
          <pc:sldMk cId="4208915042" sldId="1063"/>
        </pc:sldMkLst>
        <pc:grpChg chg="add mod">
          <ac:chgData name="McNaughton, Peter" userId="9ee63666-e0f5-407d-845c-599ffbd0ff03" providerId="ADAL" clId="{F728779B-3A18-4A15-A1D4-F744804801C5}" dt="2019-07-25T16:49:39.742" v="910" actId="1076"/>
          <ac:grpSpMkLst>
            <pc:docMk/>
            <pc:sldMk cId="4208915042" sldId="1063"/>
            <ac:grpSpMk id="2" creationId="{439B0165-1159-4EB4-A789-6C6DA58C03F9}"/>
          </ac:grpSpMkLst>
        </pc:grpChg>
        <pc:picChg chg="add mod">
          <ac:chgData name="McNaughton, Peter" userId="9ee63666-e0f5-407d-845c-599ffbd0ff03" providerId="ADAL" clId="{F728779B-3A18-4A15-A1D4-F744804801C5}" dt="2019-07-25T16:52:25.340" v="914" actId="14100"/>
          <ac:picMkLst>
            <pc:docMk/>
            <pc:sldMk cId="4208915042" sldId="1063"/>
            <ac:picMk id="5" creationId="{1D3BFC9B-521C-4A11-A7FD-C2E6A8B77013}"/>
          </ac:picMkLst>
        </pc:picChg>
      </pc:sldChg>
      <pc:sldChg chg="addSp delSp modSp add ord">
        <pc:chgData name="McNaughton, Peter" userId="9ee63666-e0f5-407d-845c-599ffbd0ff03" providerId="ADAL" clId="{F728779B-3A18-4A15-A1D4-F744804801C5}" dt="2019-07-25T16:58:28.818" v="931" actId="167"/>
        <pc:sldMkLst>
          <pc:docMk/>
          <pc:sldMk cId="3818966307" sldId="1064"/>
        </pc:sldMkLst>
        <pc:spChg chg="add mod">
          <ac:chgData name="McNaughton, Peter" userId="9ee63666-e0f5-407d-845c-599ffbd0ff03" providerId="ADAL" clId="{F728779B-3A18-4A15-A1D4-F744804801C5}" dt="2019-07-25T16:49:25.790" v="909" actId="1076"/>
          <ac:spMkLst>
            <pc:docMk/>
            <pc:sldMk cId="3818966307" sldId="1064"/>
            <ac:spMk id="6" creationId="{619220E3-5917-422A-88A2-08809313C8B6}"/>
          </ac:spMkLst>
        </pc:spChg>
        <pc:grpChg chg="add mod">
          <ac:chgData name="McNaughton, Peter" userId="9ee63666-e0f5-407d-845c-599ffbd0ff03" providerId="ADAL" clId="{F728779B-3A18-4A15-A1D4-F744804801C5}" dt="2019-07-25T16:58:11.939" v="922" actId="1076"/>
          <ac:grpSpMkLst>
            <pc:docMk/>
            <pc:sldMk cId="3818966307" sldId="1064"/>
            <ac:grpSpMk id="2" creationId="{EA66C0F6-AE6F-45E8-B9FF-810E245ABFC2}"/>
          </ac:grpSpMkLst>
        </pc:grpChg>
        <pc:picChg chg="add del">
          <ac:chgData name="McNaughton, Peter" userId="9ee63666-e0f5-407d-845c-599ffbd0ff03" providerId="ADAL" clId="{F728779B-3A18-4A15-A1D4-F744804801C5}" dt="2019-07-25T16:48:16.594" v="823" actId="478"/>
          <ac:picMkLst>
            <pc:docMk/>
            <pc:sldMk cId="3818966307" sldId="1064"/>
            <ac:picMk id="7" creationId="{C4FB1288-4F5B-46E5-B904-C144C1A637AC}"/>
          </ac:picMkLst>
        </pc:picChg>
        <pc:picChg chg="add mod ord">
          <ac:chgData name="McNaughton, Peter" userId="9ee63666-e0f5-407d-845c-599ffbd0ff03" providerId="ADAL" clId="{F728779B-3A18-4A15-A1D4-F744804801C5}" dt="2019-07-25T16:58:28.818" v="931" actId="167"/>
          <ac:picMkLst>
            <pc:docMk/>
            <pc:sldMk cId="3818966307" sldId="1064"/>
            <ac:picMk id="8" creationId="{F9340EBA-128F-4869-A81C-1C3592C920BE}"/>
          </ac:picMkLst>
        </pc:picChg>
      </pc:sldChg>
      <pc:sldChg chg="addSp delSp modSp add">
        <pc:chgData name="McNaughton, Peter" userId="9ee63666-e0f5-407d-845c-599ffbd0ff03" providerId="ADAL" clId="{F728779B-3A18-4A15-A1D4-F744804801C5}" dt="2019-07-25T15:47:46.171" v="714" actId="20577"/>
        <pc:sldMkLst>
          <pc:docMk/>
          <pc:sldMk cId="3467134952" sldId="1065"/>
        </pc:sldMkLst>
        <pc:spChg chg="add mod">
          <ac:chgData name="McNaughton, Peter" userId="9ee63666-e0f5-407d-845c-599ffbd0ff03" providerId="ADAL" clId="{F728779B-3A18-4A15-A1D4-F744804801C5}" dt="2019-07-24T17:58:55.160" v="518" actId="1076"/>
          <ac:spMkLst>
            <pc:docMk/>
            <pc:sldMk cId="3467134952" sldId="1065"/>
            <ac:spMk id="2" creationId="{D26CC8A5-FF73-4B26-BF5F-264958295457}"/>
          </ac:spMkLst>
        </pc:spChg>
        <pc:spChg chg="add del">
          <ac:chgData name="McNaughton, Peter" userId="9ee63666-e0f5-407d-845c-599ffbd0ff03" providerId="ADAL" clId="{F728779B-3A18-4A15-A1D4-F744804801C5}" dt="2019-07-24T18:07:20.931" v="520"/>
          <ac:spMkLst>
            <pc:docMk/>
            <pc:sldMk cId="3467134952" sldId="1065"/>
            <ac:spMk id="3" creationId="{3A663333-79A4-4EF8-8316-5CB23CBFE1DF}"/>
          </ac:spMkLst>
        </pc:spChg>
        <pc:spChg chg="add mod">
          <ac:chgData name="McNaughton, Peter" userId="9ee63666-e0f5-407d-845c-599ffbd0ff03" providerId="ADAL" clId="{F728779B-3A18-4A15-A1D4-F744804801C5}" dt="2019-07-25T15:47:46.171" v="714" actId="20577"/>
          <ac:spMkLst>
            <pc:docMk/>
            <pc:sldMk cId="3467134952" sldId="1065"/>
            <ac:spMk id="4" creationId="{49524E32-9F75-4FE5-B08D-AF6B13887438}"/>
          </ac:spMkLst>
        </pc:spChg>
      </pc:sldChg>
      <pc:sldChg chg="addSp delSp modSp add">
        <pc:chgData name="McNaughton, Peter" userId="9ee63666-e0f5-407d-845c-599ffbd0ff03" providerId="ADAL" clId="{F728779B-3A18-4A15-A1D4-F744804801C5}" dt="2019-07-25T16:46:57.018" v="821" actId="1076"/>
        <pc:sldMkLst>
          <pc:docMk/>
          <pc:sldMk cId="1045846588" sldId="1066"/>
        </pc:sldMkLst>
        <pc:spChg chg="add mod">
          <ac:chgData name="McNaughton, Peter" userId="9ee63666-e0f5-407d-845c-599ffbd0ff03" providerId="ADAL" clId="{F728779B-3A18-4A15-A1D4-F744804801C5}" dt="2019-07-25T16:13:56.423" v="813" actId="1036"/>
          <ac:spMkLst>
            <pc:docMk/>
            <pc:sldMk cId="1045846588" sldId="1066"/>
            <ac:spMk id="4" creationId="{280787C7-627A-4FB3-A78A-300A1BF53569}"/>
          </ac:spMkLst>
        </pc:spChg>
        <pc:picChg chg="add mod">
          <ac:chgData name="McNaughton, Peter" userId="9ee63666-e0f5-407d-845c-599ffbd0ff03" providerId="ADAL" clId="{F728779B-3A18-4A15-A1D4-F744804801C5}" dt="2019-07-25T16:10:55.982" v="774" actId="1076"/>
          <ac:picMkLst>
            <pc:docMk/>
            <pc:sldMk cId="1045846588" sldId="1066"/>
            <ac:picMk id="2" creationId="{BC382CFF-7CF1-4B6E-AEEA-E9D68EF19B47}"/>
          </ac:picMkLst>
        </pc:picChg>
        <pc:picChg chg="add del mod">
          <ac:chgData name="McNaughton, Peter" userId="9ee63666-e0f5-407d-845c-599ffbd0ff03" providerId="ADAL" clId="{F728779B-3A18-4A15-A1D4-F744804801C5}" dt="2019-07-25T16:13:34.795" v="795" actId="478"/>
          <ac:picMkLst>
            <pc:docMk/>
            <pc:sldMk cId="1045846588" sldId="1066"/>
            <ac:picMk id="3" creationId="{EA7E946E-83B9-479A-A8FF-80468C046654}"/>
          </ac:picMkLst>
        </pc:picChg>
        <pc:picChg chg="add mod">
          <ac:chgData name="McNaughton, Peter" userId="9ee63666-e0f5-407d-845c-599ffbd0ff03" providerId="ADAL" clId="{F728779B-3A18-4A15-A1D4-F744804801C5}" dt="2019-07-25T16:13:48.903" v="799" actId="1076"/>
          <ac:picMkLst>
            <pc:docMk/>
            <pc:sldMk cId="1045846588" sldId="1066"/>
            <ac:picMk id="5" creationId="{700BD18C-64C4-4A30-9D6D-4B6909B0C6E6}"/>
          </ac:picMkLst>
        </pc:picChg>
        <pc:picChg chg="add mod">
          <ac:chgData name="McNaughton, Peter" userId="9ee63666-e0f5-407d-845c-599ffbd0ff03" providerId="ADAL" clId="{F728779B-3A18-4A15-A1D4-F744804801C5}" dt="2019-07-25T16:45:38.659" v="816" actId="1076"/>
          <ac:picMkLst>
            <pc:docMk/>
            <pc:sldMk cId="1045846588" sldId="1066"/>
            <ac:picMk id="6" creationId="{492EA510-807B-4438-A8CD-8DCA2BE380BB}"/>
          </ac:picMkLst>
        </pc:picChg>
        <pc:picChg chg="add mod">
          <ac:chgData name="McNaughton, Peter" userId="9ee63666-e0f5-407d-845c-599ffbd0ff03" providerId="ADAL" clId="{F728779B-3A18-4A15-A1D4-F744804801C5}" dt="2019-07-25T16:46:57.018" v="821" actId="1076"/>
          <ac:picMkLst>
            <pc:docMk/>
            <pc:sldMk cId="1045846588" sldId="1066"/>
            <ac:picMk id="7" creationId="{0A04CE15-3EE4-4DB9-8709-57E54CD919E1}"/>
          </ac:picMkLst>
        </pc:picChg>
      </pc:sldChg>
      <pc:sldChg chg="addSp modSp add modAnim">
        <pc:chgData name="McNaughton, Peter" userId="9ee63666-e0f5-407d-845c-599ffbd0ff03" providerId="ADAL" clId="{F728779B-3A18-4A15-A1D4-F744804801C5}" dt="2019-07-26T09:38:43.032" v="990" actId="14100"/>
        <pc:sldMkLst>
          <pc:docMk/>
          <pc:sldMk cId="879679908" sldId="1067"/>
        </pc:sldMkLst>
        <pc:spChg chg="add mod">
          <ac:chgData name="McNaughton, Peter" userId="9ee63666-e0f5-407d-845c-599ffbd0ff03" providerId="ADAL" clId="{F728779B-3A18-4A15-A1D4-F744804801C5}" dt="2019-07-25T17:10:39.374" v="983" actId="14100"/>
          <ac:spMkLst>
            <pc:docMk/>
            <pc:sldMk cId="879679908" sldId="1067"/>
            <ac:spMk id="3" creationId="{33C9DBC5-339C-4CB5-BEF5-5B80D2697E1F}"/>
          </ac:spMkLst>
        </pc:spChg>
        <pc:picChg chg="add mod">
          <ac:chgData name="McNaughton, Peter" userId="9ee63666-e0f5-407d-845c-599ffbd0ff03" providerId="ADAL" clId="{F728779B-3A18-4A15-A1D4-F744804801C5}" dt="2019-07-26T09:38:43.032" v="990" actId="14100"/>
          <ac:picMkLst>
            <pc:docMk/>
            <pc:sldMk cId="879679908" sldId="1067"/>
            <ac:picMk id="2" creationId="{57959641-B2B4-4B71-A295-5D1E5D7C3C78}"/>
          </ac:picMkLst>
        </pc:picChg>
      </pc:sldChg>
      <pc:sldChg chg="addSp delSp modSp add">
        <pc:chgData name="McNaughton, Peter" userId="9ee63666-e0f5-407d-845c-599ffbd0ff03" providerId="ADAL" clId="{F728779B-3A18-4A15-A1D4-F744804801C5}" dt="2019-07-29T12:51:45.984" v="1021" actId="1076"/>
        <pc:sldMkLst>
          <pc:docMk/>
          <pc:sldMk cId="4091570391" sldId="1068"/>
        </pc:sldMkLst>
        <pc:picChg chg="del">
          <ac:chgData name="McNaughton, Peter" userId="9ee63666-e0f5-407d-845c-599ffbd0ff03" providerId="ADAL" clId="{F728779B-3A18-4A15-A1D4-F744804801C5}" dt="2019-07-29T12:51:34.132" v="1018" actId="478"/>
          <ac:picMkLst>
            <pc:docMk/>
            <pc:sldMk cId="4091570391" sldId="1068"/>
            <ac:picMk id="2" creationId="{B2F8C2DF-6AD4-40C8-9BC8-1C9A309AB2A3}"/>
          </ac:picMkLst>
        </pc:picChg>
        <pc:picChg chg="add mod">
          <ac:chgData name="McNaughton, Peter" userId="9ee63666-e0f5-407d-845c-599ffbd0ff03" providerId="ADAL" clId="{F728779B-3A18-4A15-A1D4-F744804801C5}" dt="2019-07-29T12:51:45.984" v="1021" actId="1076"/>
          <ac:picMkLst>
            <pc:docMk/>
            <pc:sldMk cId="4091570391" sldId="1068"/>
            <ac:picMk id="4" creationId="{F8BCC94B-A62B-41B2-8933-629FBE635AA6}"/>
          </ac:picMkLst>
        </pc:picChg>
      </pc:sldChg>
      <pc:sldChg chg="addSp delSp modSp">
        <pc:chgData name="McNaughton, Peter" userId="9ee63666-e0f5-407d-845c-599ffbd0ff03" providerId="ADAL" clId="{F728779B-3A18-4A15-A1D4-F744804801C5}" dt="2019-07-29T13:10:22.764" v="1694" actId="20577"/>
        <pc:sldMkLst>
          <pc:docMk/>
          <pc:sldMk cId="1505953833" sldId="1069"/>
        </pc:sldMkLst>
        <pc:spChg chg="mod">
          <ac:chgData name="McNaughton, Peter" userId="9ee63666-e0f5-407d-845c-599ffbd0ff03" providerId="ADAL" clId="{F728779B-3A18-4A15-A1D4-F744804801C5}" dt="2019-07-29T13:02:01.539" v="1063" actId="1035"/>
          <ac:spMkLst>
            <pc:docMk/>
            <pc:sldMk cId="1505953833" sldId="1069"/>
            <ac:spMk id="3" creationId="{594E72E8-34F9-4A46-A1CE-CD0BC8CD7F38}"/>
          </ac:spMkLst>
        </pc:spChg>
        <pc:spChg chg="add mod">
          <ac:chgData name="McNaughton, Peter" userId="9ee63666-e0f5-407d-845c-599ffbd0ff03" providerId="ADAL" clId="{F728779B-3A18-4A15-A1D4-F744804801C5}" dt="2019-07-29T13:10:22.764" v="1694" actId="20577"/>
          <ac:spMkLst>
            <pc:docMk/>
            <pc:sldMk cId="1505953833" sldId="1069"/>
            <ac:spMk id="6" creationId="{5AC5B15E-5AE0-49C7-950E-5FA929EFAE9A}"/>
          </ac:spMkLst>
        </pc:spChg>
        <pc:spChg chg="add mod">
          <ac:chgData name="McNaughton, Peter" userId="9ee63666-e0f5-407d-845c-599ffbd0ff03" providerId="ADAL" clId="{F728779B-3A18-4A15-A1D4-F744804801C5}" dt="2019-07-29T13:09:26.427" v="1675" actId="20577"/>
          <ac:spMkLst>
            <pc:docMk/>
            <pc:sldMk cId="1505953833" sldId="1069"/>
            <ac:spMk id="7" creationId="{EDECB891-DAD0-4310-9D3A-6F083A251941}"/>
          </ac:spMkLst>
        </pc:spChg>
        <pc:spChg chg="add mod">
          <ac:chgData name="McNaughton, Peter" userId="9ee63666-e0f5-407d-845c-599ffbd0ff03" providerId="ADAL" clId="{F728779B-3A18-4A15-A1D4-F744804801C5}" dt="2019-07-29T13:09:52.571" v="1693" actId="1037"/>
          <ac:spMkLst>
            <pc:docMk/>
            <pc:sldMk cId="1505953833" sldId="1069"/>
            <ac:spMk id="8" creationId="{1883284D-E44E-4CE7-9F30-789ECAA10E11}"/>
          </ac:spMkLst>
        </pc:spChg>
        <pc:picChg chg="del">
          <ac:chgData name="McNaughton, Peter" userId="9ee63666-e0f5-407d-845c-599ffbd0ff03" providerId="ADAL" clId="{F728779B-3A18-4A15-A1D4-F744804801C5}" dt="2019-07-29T13:01:05.894" v="1030" actId="478"/>
          <ac:picMkLst>
            <pc:docMk/>
            <pc:sldMk cId="1505953833" sldId="1069"/>
            <ac:picMk id="2" creationId="{57FF5AA0-4B12-46FF-A930-D68B405CB7D6}"/>
          </ac:picMkLst>
        </pc:picChg>
        <pc:picChg chg="mod">
          <ac:chgData name="McNaughton, Peter" userId="9ee63666-e0f5-407d-845c-599ffbd0ff03" providerId="ADAL" clId="{F728779B-3A18-4A15-A1D4-F744804801C5}" dt="2019-07-29T13:08:57.465" v="1631" actId="1076"/>
          <ac:picMkLst>
            <pc:docMk/>
            <pc:sldMk cId="1505953833" sldId="1069"/>
            <ac:picMk id="4" creationId="{1A9AA24E-078C-4FF6-AEE1-666AD08FEC82}"/>
          </ac:picMkLst>
        </pc:picChg>
        <pc:picChg chg="add mod">
          <ac:chgData name="McNaughton, Peter" userId="9ee63666-e0f5-407d-845c-599ffbd0ff03" providerId="ADAL" clId="{F728779B-3A18-4A15-A1D4-F744804801C5}" dt="2019-07-29T13:07:57.103" v="1579" actId="1076"/>
          <ac:picMkLst>
            <pc:docMk/>
            <pc:sldMk cId="1505953833" sldId="1069"/>
            <ac:picMk id="5" creationId="{A5E2F246-8F85-44E1-B680-AA3871CB6CA6}"/>
          </ac:picMkLst>
        </pc:picChg>
      </pc:sldChg>
      <pc:sldChg chg="modSp">
        <pc:chgData name="McNaughton, Peter" userId="9ee63666-e0f5-407d-845c-599ffbd0ff03" providerId="ADAL" clId="{F728779B-3A18-4A15-A1D4-F744804801C5}" dt="2019-07-29T12:47:23.343" v="1017" actId="20577"/>
        <pc:sldMkLst>
          <pc:docMk/>
          <pc:sldMk cId="804174262" sldId="1072"/>
        </pc:sldMkLst>
        <pc:spChg chg="mod">
          <ac:chgData name="McNaughton, Peter" userId="9ee63666-e0f5-407d-845c-599ffbd0ff03" providerId="ADAL" clId="{F728779B-3A18-4A15-A1D4-F744804801C5}" dt="2019-07-29T12:47:23.343" v="1017" actId="20577"/>
          <ac:spMkLst>
            <pc:docMk/>
            <pc:sldMk cId="804174262" sldId="1072"/>
            <ac:spMk id="2" creationId="{3DAB31B9-A013-4822-9FA4-2455BA7A3ABA}"/>
          </ac:spMkLst>
        </pc:spChg>
      </pc:sldChg>
    </pc:docChg>
  </pc:docChgLst>
  <pc:docChgLst>
    <pc:chgData name="McNaughton, Peter" userId="9ee63666-e0f5-407d-845c-599ffbd0ff03" providerId="ADAL" clId="{148754AB-C4BD-4FCA-9E9E-38CA2152BC00}"/>
    <pc:docChg chg="modSld">
      <pc:chgData name="McNaughton, Peter" userId="9ee63666-e0f5-407d-845c-599ffbd0ff03" providerId="ADAL" clId="{148754AB-C4BD-4FCA-9E9E-38CA2152BC00}" dt="2019-07-17T08:01:31.181" v="6" actId="14100"/>
      <pc:docMkLst>
        <pc:docMk/>
      </pc:docMkLst>
    </pc:docChg>
  </pc:docChgLst>
  <pc:docChgLst>
    <pc:chgData name="Peter McNaughton" userId="9ee63666-e0f5-407d-845c-599ffbd0ff03" providerId="ADAL" clId="{BD2D4AB9-A361-4F11-A3A3-889B775F1A05}"/>
    <pc:docChg chg="custSel addSld delSld modSld sldOrd">
      <pc:chgData name="Peter McNaughton" userId="9ee63666-e0f5-407d-845c-599ffbd0ff03" providerId="ADAL" clId="{BD2D4AB9-A361-4F11-A3A3-889B775F1A05}" dt="2019-08-02T10:22:29.782" v="144" actId="1036"/>
      <pc:docMkLst>
        <pc:docMk/>
      </pc:docMkLst>
      <pc:sldChg chg="modSp ord">
        <pc:chgData name="Peter McNaughton" userId="9ee63666-e0f5-407d-845c-599ffbd0ff03" providerId="ADAL" clId="{BD2D4AB9-A361-4F11-A3A3-889B775F1A05}" dt="2019-07-26T08:29:29.254" v="127" actId="1038"/>
        <pc:sldMkLst>
          <pc:docMk/>
          <pc:sldMk cId="967794767" sldId="1043"/>
        </pc:sldMkLst>
        <pc:spChg chg="mod">
          <ac:chgData name="Peter McNaughton" userId="9ee63666-e0f5-407d-845c-599ffbd0ff03" providerId="ADAL" clId="{BD2D4AB9-A361-4F11-A3A3-889B775F1A05}" dt="2019-07-26T08:29:29.254" v="127" actId="1038"/>
          <ac:spMkLst>
            <pc:docMk/>
            <pc:sldMk cId="967794767" sldId="1043"/>
            <ac:spMk id="7" creationId="{76AF923D-B7A6-4611-A63B-92181EDF3954}"/>
          </ac:spMkLst>
        </pc:spChg>
      </pc:sldChg>
      <pc:sldChg chg="modSp">
        <pc:chgData name="Peter McNaughton" userId="9ee63666-e0f5-407d-845c-599ffbd0ff03" providerId="ADAL" clId="{BD2D4AB9-A361-4F11-A3A3-889B775F1A05}" dt="2019-07-26T08:25:22.071" v="120" actId="255"/>
        <pc:sldMkLst>
          <pc:docMk/>
          <pc:sldMk cId="1374863980" sldId="1047"/>
        </pc:sldMkLst>
        <pc:spChg chg="mod">
          <ac:chgData name="Peter McNaughton" userId="9ee63666-e0f5-407d-845c-599ffbd0ff03" providerId="ADAL" clId="{BD2D4AB9-A361-4F11-A3A3-889B775F1A05}" dt="2019-07-26T08:25:22.071" v="120" actId="255"/>
          <ac:spMkLst>
            <pc:docMk/>
            <pc:sldMk cId="1374863980" sldId="1047"/>
            <ac:spMk id="7" creationId="{84070474-163C-48F2-A3C2-BBBDA4D440B5}"/>
          </ac:spMkLst>
        </pc:spChg>
      </pc:sldChg>
      <pc:sldChg chg="addSp delSp">
        <pc:chgData name="Peter McNaughton" userId="9ee63666-e0f5-407d-845c-599ffbd0ff03" providerId="ADAL" clId="{BD2D4AB9-A361-4F11-A3A3-889B775F1A05}" dt="2019-07-26T08:23:30.966" v="84"/>
        <pc:sldMkLst>
          <pc:docMk/>
          <pc:sldMk cId="1166270232" sldId="1061"/>
        </pc:sldMkLst>
        <pc:spChg chg="del">
          <ac:chgData name="Peter McNaughton" userId="9ee63666-e0f5-407d-845c-599ffbd0ff03" providerId="ADAL" clId="{BD2D4AB9-A361-4F11-A3A3-889B775F1A05}" dt="2019-07-26T08:22:51.598" v="82" actId="478"/>
          <ac:spMkLst>
            <pc:docMk/>
            <pc:sldMk cId="1166270232" sldId="1061"/>
            <ac:spMk id="5" creationId="{003F7EB9-5822-4FA9-9145-C1BDD5E937F1}"/>
          </ac:spMkLst>
        </pc:spChg>
        <pc:spChg chg="add">
          <ac:chgData name="Peter McNaughton" userId="9ee63666-e0f5-407d-845c-599ffbd0ff03" providerId="ADAL" clId="{BD2D4AB9-A361-4F11-A3A3-889B775F1A05}" dt="2019-07-26T08:23:30.966" v="84"/>
          <ac:spMkLst>
            <pc:docMk/>
            <pc:sldMk cId="1166270232" sldId="1061"/>
            <ac:spMk id="6" creationId="{FBC28872-D9F9-4879-B0D0-5BB282C8411B}"/>
          </ac:spMkLst>
        </pc:spChg>
      </pc:sldChg>
      <pc:sldChg chg="modSp modAnim">
        <pc:chgData name="Peter McNaughton" userId="9ee63666-e0f5-407d-845c-599ffbd0ff03" providerId="ADAL" clId="{BD2D4AB9-A361-4F11-A3A3-889B775F1A05}" dt="2019-07-26T08:24:48.251" v="118"/>
        <pc:sldMkLst>
          <pc:docMk/>
          <pc:sldMk cId="3818966307" sldId="1064"/>
        </pc:sldMkLst>
        <pc:spChg chg="mod">
          <ac:chgData name="Peter McNaughton" userId="9ee63666-e0f5-407d-845c-599ffbd0ff03" providerId="ADAL" clId="{BD2D4AB9-A361-4F11-A3A3-889B775F1A05}" dt="2019-07-26T08:24:34.039" v="117" actId="14100"/>
          <ac:spMkLst>
            <pc:docMk/>
            <pc:sldMk cId="3818966307" sldId="1064"/>
            <ac:spMk id="6" creationId="{619220E3-5917-422A-88A2-08809313C8B6}"/>
          </ac:spMkLst>
        </pc:spChg>
      </pc:sldChg>
      <pc:sldChg chg="modSp">
        <pc:chgData name="Peter McNaughton" userId="9ee63666-e0f5-407d-845c-599ffbd0ff03" providerId="ADAL" clId="{BD2D4AB9-A361-4F11-A3A3-889B775F1A05}" dt="2019-07-26T08:25:08.818" v="119" actId="255"/>
        <pc:sldMkLst>
          <pc:docMk/>
          <pc:sldMk cId="3467134952" sldId="1065"/>
        </pc:sldMkLst>
        <pc:spChg chg="mod">
          <ac:chgData name="Peter McNaughton" userId="9ee63666-e0f5-407d-845c-599ffbd0ff03" providerId="ADAL" clId="{BD2D4AB9-A361-4F11-A3A3-889B775F1A05}" dt="2019-07-26T08:25:08.818" v="119" actId="255"/>
          <ac:spMkLst>
            <pc:docMk/>
            <pc:sldMk cId="3467134952" sldId="1065"/>
            <ac:spMk id="4" creationId="{49524E32-9F75-4FE5-B08D-AF6B13887438}"/>
          </ac:spMkLst>
        </pc:spChg>
      </pc:sldChg>
      <pc:sldChg chg="addSp modSp">
        <pc:chgData name="Peter McNaughton" userId="9ee63666-e0f5-407d-845c-599ffbd0ff03" providerId="ADAL" clId="{BD2D4AB9-A361-4F11-A3A3-889B775F1A05}" dt="2019-07-26T08:15:15.868" v="28" actId="20577"/>
        <pc:sldMkLst>
          <pc:docMk/>
          <pc:sldMk cId="4091570391" sldId="1068"/>
        </pc:sldMkLst>
        <pc:spChg chg="add mod">
          <ac:chgData name="Peter McNaughton" userId="9ee63666-e0f5-407d-845c-599ffbd0ff03" providerId="ADAL" clId="{BD2D4AB9-A361-4F11-A3A3-889B775F1A05}" dt="2019-07-26T08:15:15.868" v="28" actId="20577"/>
          <ac:spMkLst>
            <pc:docMk/>
            <pc:sldMk cId="4091570391" sldId="1068"/>
            <ac:spMk id="3" creationId="{1A1D469B-17BD-4F93-8CDB-AB968E814486}"/>
          </ac:spMkLst>
        </pc:spChg>
        <pc:picChg chg="add mod">
          <ac:chgData name="Peter McNaughton" userId="9ee63666-e0f5-407d-845c-599ffbd0ff03" providerId="ADAL" clId="{BD2D4AB9-A361-4F11-A3A3-889B775F1A05}" dt="2019-07-26T08:14:39.486" v="2" actId="1076"/>
          <ac:picMkLst>
            <pc:docMk/>
            <pc:sldMk cId="4091570391" sldId="1068"/>
            <ac:picMk id="2" creationId="{B2F8C2DF-6AD4-40C8-9BC8-1C9A309AB2A3}"/>
          </ac:picMkLst>
        </pc:picChg>
      </pc:sldChg>
      <pc:sldChg chg="addSp modSp add modAnim">
        <pc:chgData name="Peter McNaughton" userId="9ee63666-e0f5-407d-845c-599ffbd0ff03" providerId="ADAL" clId="{BD2D4AB9-A361-4F11-A3A3-889B775F1A05}" dt="2019-08-02T10:22:29.782" v="144" actId="1036"/>
        <pc:sldMkLst>
          <pc:docMk/>
          <pc:sldMk cId="1505953833" sldId="1069"/>
        </pc:sldMkLst>
        <pc:spChg chg="add mod">
          <ac:chgData name="Peter McNaughton" userId="9ee63666-e0f5-407d-845c-599ffbd0ff03" providerId="ADAL" clId="{BD2D4AB9-A361-4F11-A3A3-889B775F1A05}" dt="2019-07-26T08:16:58.200" v="76" actId="20577"/>
          <ac:spMkLst>
            <pc:docMk/>
            <pc:sldMk cId="1505953833" sldId="1069"/>
            <ac:spMk id="3" creationId="{594E72E8-34F9-4A46-A1CE-CD0BC8CD7F38}"/>
          </ac:spMkLst>
        </pc:spChg>
        <pc:spChg chg="mod">
          <ac:chgData name="Peter McNaughton" userId="9ee63666-e0f5-407d-845c-599ffbd0ff03" providerId="ADAL" clId="{BD2D4AB9-A361-4F11-A3A3-889B775F1A05}" dt="2019-08-02T10:22:29.782" v="144" actId="1036"/>
          <ac:spMkLst>
            <pc:docMk/>
            <pc:sldMk cId="1505953833" sldId="1069"/>
            <ac:spMk id="6" creationId="{5AC5B15E-5AE0-49C7-950E-5FA929EFAE9A}"/>
          </ac:spMkLst>
        </pc:spChg>
        <pc:picChg chg="add mod">
          <ac:chgData name="Peter McNaughton" userId="9ee63666-e0f5-407d-845c-599ffbd0ff03" providerId="ADAL" clId="{BD2D4AB9-A361-4F11-A3A3-889B775F1A05}" dt="2019-07-26T08:15:56.634" v="32" actId="1076"/>
          <ac:picMkLst>
            <pc:docMk/>
            <pc:sldMk cId="1505953833" sldId="1069"/>
            <ac:picMk id="2" creationId="{57FF5AA0-4B12-46FF-A930-D68B405CB7D6}"/>
          </ac:picMkLst>
        </pc:picChg>
        <pc:picChg chg="add mod">
          <ac:chgData name="Peter McNaughton" userId="9ee63666-e0f5-407d-845c-599ffbd0ff03" providerId="ADAL" clId="{BD2D4AB9-A361-4F11-A3A3-889B775F1A05}" dt="2019-07-26T08:17:39.241" v="80" actId="1076"/>
          <ac:picMkLst>
            <pc:docMk/>
            <pc:sldMk cId="1505953833" sldId="1069"/>
            <ac:picMk id="4" creationId="{1A9AA24E-078C-4FF6-AEE1-666AD08FEC82}"/>
          </ac:picMkLst>
        </pc:picChg>
      </pc:sldChg>
      <pc:sldChg chg="addSp modSp add">
        <pc:chgData name="Peter McNaughton" userId="9ee63666-e0f5-407d-845c-599ffbd0ff03" providerId="ADAL" clId="{BD2D4AB9-A361-4F11-A3A3-889B775F1A05}" dt="2019-07-26T08:30:46.031" v="130" actId="14100"/>
        <pc:sldMkLst>
          <pc:docMk/>
          <pc:sldMk cId="1315797268" sldId="1070"/>
        </pc:sldMkLst>
        <pc:picChg chg="add mod">
          <ac:chgData name="Peter McNaughton" userId="9ee63666-e0f5-407d-845c-599ffbd0ff03" providerId="ADAL" clId="{BD2D4AB9-A361-4F11-A3A3-889B775F1A05}" dt="2019-07-26T08:30:46.031" v="130" actId="14100"/>
          <ac:picMkLst>
            <pc:docMk/>
            <pc:sldMk cId="1315797268" sldId="1070"/>
            <ac:picMk id="2" creationId="{E0EE34AA-A1F2-42A7-BE61-D6A2108BC8F9}"/>
          </ac:picMkLst>
        </pc:picChg>
      </pc:sldChg>
    </pc:docChg>
  </pc:docChgLst>
  <pc:docChgLst>
    <pc:chgData name="McNaughton, Peter" userId="9ee63666-e0f5-407d-845c-599ffbd0ff03" providerId="ADAL" clId="{F4CB62D7-FFA5-4144-BE0D-6D9DB5129E4A}"/>
    <pc:docChg chg="custSel modSld">
      <pc:chgData name="McNaughton, Peter" userId="9ee63666-e0f5-407d-845c-599ffbd0ff03" providerId="ADAL" clId="{F4CB62D7-FFA5-4144-BE0D-6D9DB5129E4A}" dt="2020-08-13T16:46:11.791" v="380" actId="20577"/>
      <pc:docMkLst>
        <pc:docMk/>
      </pc:docMkLst>
      <pc:sldChg chg="modSp mod">
        <pc:chgData name="McNaughton, Peter" userId="9ee63666-e0f5-407d-845c-599ffbd0ff03" providerId="ADAL" clId="{F4CB62D7-FFA5-4144-BE0D-6D9DB5129E4A}" dt="2020-08-13T16:46:11.791" v="380" actId="20577"/>
        <pc:sldMkLst>
          <pc:docMk/>
          <pc:sldMk cId="879679908" sldId="1067"/>
        </pc:sldMkLst>
        <pc:spChg chg="mod">
          <ac:chgData name="McNaughton, Peter" userId="9ee63666-e0f5-407d-845c-599ffbd0ff03" providerId="ADAL" clId="{F4CB62D7-FFA5-4144-BE0D-6D9DB5129E4A}" dt="2020-08-13T16:46:11.791" v="380" actId="20577"/>
          <ac:spMkLst>
            <pc:docMk/>
            <pc:sldMk cId="879679908" sldId="1067"/>
            <ac:spMk id="3" creationId="{33C9DBC5-339C-4CB5-BEF5-5B80D2697E1F}"/>
          </ac:spMkLst>
        </pc:spChg>
        <pc:picChg chg="mod">
          <ac:chgData name="McNaughton, Peter" userId="9ee63666-e0f5-407d-845c-599ffbd0ff03" providerId="ADAL" clId="{F4CB62D7-FFA5-4144-BE0D-6D9DB5129E4A}" dt="2020-08-13T16:45:55.474" v="377" actId="1035"/>
          <ac:picMkLst>
            <pc:docMk/>
            <pc:sldMk cId="879679908" sldId="1067"/>
            <ac:picMk id="2" creationId="{57959641-B2B4-4B71-A295-5D1E5D7C3C78}"/>
          </ac:picMkLst>
        </pc:pic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9698" name="Rectangle 2"/>
          <p:cNvSpPr>
            <a:spLocks noGrp="1" noChangeArrowheads="1"/>
          </p:cNvSpPr>
          <p:nvPr>
            <p:ph type="hdr" sz="quarter"/>
          </p:nvPr>
        </p:nvSpPr>
        <p:spPr bwMode="auto">
          <a:xfrm>
            <a:off x="0" y="0"/>
            <a:ext cx="29718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l">
              <a:defRPr sz="1200" b="0">
                <a:cs typeface="+mn-cs"/>
              </a:defRPr>
            </a:lvl1pPr>
          </a:lstStyle>
          <a:p>
            <a:pPr>
              <a:defRPr/>
            </a:pPr>
            <a:endParaRPr lang="it-IT"/>
          </a:p>
        </p:txBody>
      </p:sp>
      <p:sp>
        <p:nvSpPr>
          <p:cNvPr id="29699" name="Rectangle 3"/>
          <p:cNvSpPr>
            <a:spLocks noGrp="1" noChangeArrowheads="1"/>
          </p:cNvSpPr>
          <p:nvPr>
            <p:ph type="dt" sz="quarter" idx="1"/>
          </p:nvPr>
        </p:nvSpPr>
        <p:spPr bwMode="auto">
          <a:xfrm>
            <a:off x="3886200" y="0"/>
            <a:ext cx="29718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200" b="0">
                <a:cs typeface="+mn-cs"/>
              </a:defRPr>
            </a:lvl1pPr>
          </a:lstStyle>
          <a:p>
            <a:pPr>
              <a:defRPr/>
            </a:pPr>
            <a:endParaRPr lang="it-IT"/>
          </a:p>
        </p:txBody>
      </p:sp>
      <p:sp>
        <p:nvSpPr>
          <p:cNvPr id="29700" name="Rectangle 4"/>
          <p:cNvSpPr>
            <a:spLocks noGrp="1" noChangeArrowheads="1"/>
          </p:cNvSpPr>
          <p:nvPr>
            <p:ph type="ftr" sz="quarter" idx="2"/>
          </p:nvPr>
        </p:nvSpPr>
        <p:spPr bwMode="auto">
          <a:xfrm>
            <a:off x="0" y="8686800"/>
            <a:ext cx="29718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l">
              <a:defRPr sz="1200" b="0">
                <a:cs typeface="+mn-cs"/>
              </a:defRPr>
            </a:lvl1pPr>
          </a:lstStyle>
          <a:p>
            <a:pPr>
              <a:defRPr/>
            </a:pPr>
            <a:endParaRPr lang="it-IT"/>
          </a:p>
        </p:txBody>
      </p:sp>
      <p:sp>
        <p:nvSpPr>
          <p:cNvPr id="29701" name="Rectangle 5"/>
          <p:cNvSpPr>
            <a:spLocks noGrp="1" noChangeArrowheads="1"/>
          </p:cNvSpPr>
          <p:nvPr>
            <p:ph type="sldNum" sz="quarter" idx="3"/>
          </p:nvPr>
        </p:nvSpPr>
        <p:spPr bwMode="auto">
          <a:xfrm>
            <a:off x="3886200" y="8686800"/>
            <a:ext cx="29718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sz="1200" b="0">
                <a:cs typeface="+mn-cs"/>
              </a:defRPr>
            </a:lvl1pPr>
          </a:lstStyle>
          <a:p>
            <a:pPr>
              <a:defRPr/>
            </a:pPr>
            <a:fld id="{87DD6C35-B7CA-4497-9254-64F4413E4F2E}" type="slidenum">
              <a:rPr lang="it-IT"/>
              <a:pPr>
                <a:defRPr/>
              </a:pPr>
              <a:t>‹#›</a:t>
            </a:fld>
            <a:endParaRPr lang="it-IT"/>
          </a:p>
        </p:txBody>
      </p:sp>
    </p:spTree>
    <p:extLst>
      <p:ext uri="{BB962C8B-B14F-4D97-AF65-F5344CB8AC3E}">
        <p14:creationId xmlns:p14="http://schemas.microsoft.com/office/powerpoint/2010/main" val="254527941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8674" name="Rectangle 2"/>
          <p:cNvSpPr>
            <a:spLocks noGrp="1" noChangeArrowheads="1"/>
          </p:cNvSpPr>
          <p:nvPr>
            <p:ph type="hdr" sz="quarter"/>
          </p:nvPr>
        </p:nvSpPr>
        <p:spPr bwMode="auto">
          <a:xfrm>
            <a:off x="0" y="0"/>
            <a:ext cx="29718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l">
              <a:defRPr sz="1200" b="0">
                <a:cs typeface="+mn-cs"/>
              </a:defRPr>
            </a:lvl1pPr>
          </a:lstStyle>
          <a:p>
            <a:pPr>
              <a:defRPr/>
            </a:pPr>
            <a:endParaRPr lang="it-IT"/>
          </a:p>
        </p:txBody>
      </p:sp>
      <p:sp>
        <p:nvSpPr>
          <p:cNvPr id="28675" name="Rectangle 3"/>
          <p:cNvSpPr>
            <a:spLocks noGrp="1" noChangeArrowheads="1"/>
          </p:cNvSpPr>
          <p:nvPr>
            <p:ph type="dt" idx="1"/>
          </p:nvPr>
        </p:nvSpPr>
        <p:spPr bwMode="auto">
          <a:xfrm>
            <a:off x="3886200" y="0"/>
            <a:ext cx="29718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200" b="0">
                <a:cs typeface="+mn-cs"/>
              </a:defRPr>
            </a:lvl1pPr>
          </a:lstStyle>
          <a:p>
            <a:pPr>
              <a:defRPr/>
            </a:pPr>
            <a:endParaRPr lang="it-IT"/>
          </a:p>
        </p:txBody>
      </p:sp>
      <p:sp>
        <p:nvSpPr>
          <p:cNvPr id="24580" name="Rectangle 4"/>
          <p:cNvSpPr>
            <a:spLocks noGrp="1" noRot="1" noChangeAspect="1" noChangeArrowheads="1" noTextEdit="1"/>
          </p:cNvSpPr>
          <p:nvPr>
            <p:ph type="sldImg" idx="2"/>
          </p:nvPr>
        </p:nvSpPr>
        <p:spPr bwMode="auto">
          <a:xfrm>
            <a:off x="952500" y="685800"/>
            <a:ext cx="4953000" cy="3429000"/>
          </a:xfrm>
          <a:prstGeom prst="rect">
            <a:avLst/>
          </a:prstGeom>
          <a:noFill/>
          <a:ln w="9525">
            <a:solidFill>
              <a:srgbClr val="000000"/>
            </a:solidFill>
            <a:miter lim="800000"/>
            <a:headEnd/>
            <a:tailEnd/>
          </a:ln>
        </p:spPr>
      </p:sp>
      <p:sp>
        <p:nvSpPr>
          <p:cNvPr id="28677" name="Rectangle 5"/>
          <p:cNvSpPr>
            <a:spLocks noGrp="1" noChangeArrowheads="1"/>
          </p:cNvSpPr>
          <p:nvPr>
            <p:ph type="body" sz="quarter" idx="3"/>
          </p:nvPr>
        </p:nvSpPr>
        <p:spPr bwMode="auto">
          <a:xfrm>
            <a:off x="914400" y="4343400"/>
            <a:ext cx="5029200" cy="41148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p>
            <a:pPr lvl="0"/>
            <a:r>
              <a:rPr lang="it-IT" noProof="0"/>
              <a:t>Fare clic per modificare gli stili del testo dello schema</a:t>
            </a:r>
          </a:p>
          <a:p>
            <a:pPr lvl="1"/>
            <a:r>
              <a:rPr lang="it-IT" noProof="0"/>
              <a:t>Secondo livello</a:t>
            </a:r>
          </a:p>
          <a:p>
            <a:pPr lvl="2"/>
            <a:r>
              <a:rPr lang="it-IT" noProof="0"/>
              <a:t>Terzo livello</a:t>
            </a:r>
          </a:p>
          <a:p>
            <a:pPr lvl="3"/>
            <a:r>
              <a:rPr lang="it-IT" noProof="0"/>
              <a:t>Quarto livello</a:t>
            </a:r>
          </a:p>
          <a:p>
            <a:pPr lvl="4"/>
            <a:r>
              <a:rPr lang="it-IT" noProof="0"/>
              <a:t>Quinto livello</a:t>
            </a:r>
          </a:p>
        </p:txBody>
      </p:sp>
      <p:sp>
        <p:nvSpPr>
          <p:cNvPr id="28678" name="Rectangle 6"/>
          <p:cNvSpPr>
            <a:spLocks noGrp="1" noChangeArrowheads="1"/>
          </p:cNvSpPr>
          <p:nvPr>
            <p:ph type="ftr" sz="quarter" idx="4"/>
          </p:nvPr>
        </p:nvSpPr>
        <p:spPr bwMode="auto">
          <a:xfrm>
            <a:off x="0" y="8686800"/>
            <a:ext cx="29718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l">
              <a:defRPr sz="1200" b="0">
                <a:cs typeface="+mn-cs"/>
              </a:defRPr>
            </a:lvl1pPr>
          </a:lstStyle>
          <a:p>
            <a:pPr>
              <a:defRPr/>
            </a:pPr>
            <a:endParaRPr lang="it-IT"/>
          </a:p>
        </p:txBody>
      </p:sp>
      <p:sp>
        <p:nvSpPr>
          <p:cNvPr id="28679" name="Rectangle 7"/>
          <p:cNvSpPr>
            <a:spLocks noGrp="1" noChangeArrowheads="1"/>
          </p:cNvSpPr>
          <p:nvPr>
            <p:ph type="sldNum" sz="quarter" idx="5"/>
          </p:nvPr>
        </p:nvSpPr>
        <p:spPr bwMode="auto">
          <a:xfrm>
            <a:off x="3886200" y="8686800"/>
            <a:ext cx="29718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sz="1200" b="0">
                <a:cs typeface="+mn-cs"/>
              </a:defRPr>
            </a:lvl1pPr>
          </a:lstStyle>
          <a:p>
            <a:pPr>
              <a:defRPr/>
            </a:pPr>
            <a:fld id="{679176E5-CA48-4F92-9B87-26E3F2D75F42}" type="slidenum">
              <a:rPr lang="it-IT"/>
              <a:pPr>
                <a:defRPr/>
              </a:pPr>
              <a:t>‹#›</a:t>
            </a:fld>
            <a:endParaRPr lang="it-IT"/>
          </a:p>
        </p:txBody>
      </p:sp>
    </p:spTree>
    <p:extLst>
      <p:ext uri="{BB962C8B-B14F-4D97-AF65-F5344CB8AC3E}">
        <p14:creationId xmlns:p14="http://schemas.microsoft.com/office/powerpoint/2010/main" val="4245283044"/>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Times New Roman" pitchFamily="18" charset="0"/>
        <a:ea typeface="+mn-ea"/>
        <a:cs typeface="+mn-cs"/>
      </a:defRPr>
    </a:lvl1pPr>
    <a:lvl2pPr marL="457200" algn="l" rtl="0" eaLnBrk="0" fontAlgn="base" hangingPunct="0">
      <a:spcBef>
        <a:spcPct val="30000"/>
      </a:spcBef>
      <a:spcAft>
        <a:spcPct val="0"/>
      </a:spcAft>
      <a:defRPr sz="1200" kern="1200">
        <a:solidFill>
          <a:schemeClr val="tx1"/>
        </a:solidFill>
        <a:latin typeface="Times New Roman" pitchFamily="18" charset="0"/>
        <a:ea typeface="+mn-ea"/>
        <a:cs typeface="+mn-cs"/>
      </a:defRPr>
    </a:lvl2pPr>
    <a:lvl3pPr marL="914400" algn="l" rtl="0" eaLnBrk="0" fontAlgn="base" hangingPunct="0">
      <a:spcBef>
        <a:spcPct val="30000"/>
      </a:spcBef>
      <a:spcAft>
        <a:spcPct val="0"/>
      </a:spcAft>
      <a:defRPr sz="1200" kern="1200">
        <a:solidFill>
          <a:schemeClr val="tx1"/>
        </a:solidFill>
        <a:latin typeface="Times New Roman" pitchFamily="18" charset="0"/>
        <a:ea typeface="+mn-ea"/>
        <a:cs typeface="+mn-cs"/>
      </a:defRPr>
    </a:lvl3pPr>
    <a:lvl4pPr marL="1371600" algn="l" rtl="0" eaLnBrk="0" fontAlgn="base" hangingPunct="0">
      <a:spcBef>
        <a:spcPct val="30000"/>
      </a:spcBef>
      <a:spcAft>
        <a:spcPct val="0"/>
      </a:spcAft>
      <a:defRPr sz="1200" kern="1200">
        <a:solidFill>
          <a:schemeClr val="tx1"/>
        </a:solidFill>
        <a:latin typeface="Times New Roman" pitchFamily="18" charset="0"/>
        <a:ea typeface="+mn-ea"/>
        <a:cs typeface="+mn-cs"/>
      </a:defRPr>
    </a:lvl4pPr>
    <a:lvl5pPr marL="1828800" algn="l" rtl="0" eaLnBrk="0" fontAlgn="base" hangingPunct="0">
      <a:spcBef>
        <a:spcPct val="30000"/>
      </a:spcBef>
      <a:spcAft>
        <a:spcPct val="0"/>
      </a:spcAft>
      <a:defRPr sz="1200" kern="1200">
        <a:solidFill>
          <a:schemeClr val="tx1"/>
        </a:solidFill>
        <a:latin typeface="Times New Roman" pitchFamily="18"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2130427"/>
            <a:ext cx="8420100" cy="1470025"/>
          </a:xfrm>
        </p:spPr>
        <p:txBody>
          <a:bodyPr/>
          <a:lstStyle/>
          <a:p>
            <a:r>
              <a:rPr lang="en-US"/>
              <a:t>Click to edit Master title style</a:t>
            </a:r>
          </a:p>
        </p:txBody>
      </p:sp>
      <p:sp>
        <p:nvSpPr>
          <p:cNvPr id="3" name="Subtitle 2"/>
          <p:cNvSpPr>
            <a:spLocks noGrp="1"/>
          </p:cNvSpPr>
          <p:nvPr>
            <p:ph type="subTitle" idx="1"/>
          </p:nvPr>
        </p:nvSpPr>
        <p:spPr>
          <a:xfrm>
            <a:off x="1485900" y="3886200"/>
            <a:ext cx="69342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Rectangle 4"/>
          <p:cNvSpPr>
            <a:spLocks noGrp="1" noChangeArrowheads="1"/>
          </p:cNvSpPr>
          <p:nvPr>
            <p:ph type="dt" sz="half" idx="10"/>
          </p:nvPr>
        </p:nvSpPr>
        <p:spPr>
          <a:ln/>
        </p:spPr>
        <p:txBody>
          <a:bodyPr/>
          <a:lstStyle>
            <a:lvl1pPr>
              <a:defRPr/>
            </a:lvl1pPr>
          </a:lstStyle>
          <a:p>
            <a:pPr>
              <a:defRPr/>
            </a:pPr>
            <a:endParaRPr lang="it-IT"/>
          </a:p>
        </p:txBody>
      </p:sp>
      <p:sp>
        <p:nvSpPr>
          <p:cNvPr id="5" name="Rectangle 5"/>
          <p:cNvSpPr>
            <a:spLocks noGrp="1" noChangeArrowheads="1"/>
          </p:cNvSpPr>
          <p:nvPr>
            <p:ph type="ftr" sz="quarter" idx="11"/>
          </p:nvPr>
        </p:nvSpPr>
        <p:spPr>
          <a:ln/>
        </p:spPr>
        <p:txBody>
          <a:bodyPr/>
          <a:lstStyle>
            <a:lvl1pPr>
              <a:defRPr/>
            </a:lvl1pPr>
          </a:lstStyle>
          <a:p>
            <a:pPr>
              <a:defRPr/>
            </a:pPr>
            <a:endParaRPr lang="it-IT"/>
          </a:p>
        </p:txBody>
      </p:sp>
      <p:sp>
        <p:nvSpPr>
          <p:cNvPr id="6" name="Rectangle 6"/>
          <p:cNvSpPr>
            <a:spLocks noGrp="1" noChangeArrowheads="1"/>
          </p:cNvSpPr>
          <p:nvPr>
            <p:ph type="sldNum" sz="quarter" idx="12"/>
          </p:nvPr>
        </p:nvSpPr>
        <p:spPr>
          <a:ln/>
        </p:spPr>
        <p:txBody>
          <a:bodyPr/>
          <a:lstStyle>
            <a:lvl1pPr>
              <a:defRPr/>
            </a:lvl1pPr>
          </a:lstStyle>
          <a:p>
            <a:pPr>
              <a:defRPr/>
            </a:pPr>
            <a:fld id="{A668FAA4-E13E-4987-A66C-E8268F6F140D}" type="slidenum">
              <a:rPr lang="it-IT"/>
              <a:pPr>
                <a:defRPr/>
              </a:pPr>
              <a:t>‹#›</a:t>
            </a:fld>
            <a:endParaRPr lang="it-IT"/>
          </a:p>
        </p:txBody>
      </p:sp>
    </p:spTree>
  </p:cSld>
  <p:clrMapOvr>
    <a:masterClrMapping/>
  </p:clrMapOvr>
  <p:transition>
    <p:zoom/>
  </p:transition>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it-IT"/>
          </a:p>
        </p:txBody>
      </p:sp>
      <p:sp>
        <p:nvSpPr>
          <p:cNvPr id="5" name="Rectangle 5"/>
          <p:cNvSpPr>
            <a:spLocks noGrp="1" noChangeArrowheads="1"/>
          </p:cNvSpPr>
          <p:nvPr>
            <p:ph type="ftr" sz="quarter" idx="11"/>
          </p:nvPr>
        </p:nvSpPr>
        <p:spPr>
          <a:ln/>
        </p:spPr>
        <p:txBody>
          <a:bodyPr/>
          <a:lstStyle>
            <a:lvl1pPr>
              <a:defRPr/>
            </a:lvl1pPr>
          </a:lstStyle>
          <a:p>
            <a:pPr>
              <a:defRPr/>
            </a:pPr>
            <a:endParaRPr lang="it-IT"/>
          </a:p>
        </p:txBody>
      </p:sp>
      <p:sp>
        <p:nvSpPr>
          <p:cNvPr id="6" name="Rectangle 6"/>
          <p:cNvSpPr>
            <a:spLocks noGrp="1" noChangeArrowheads="1"/>
          </p:cNvSpPr>
          <p:nvPr>
            <p:ph type="sldNum" sz="quarter" idx="12"/>
          </p:nvPr>
        </p:nvSpPr>
        <p:spPr>
          <a:ln/>
        </p:spPr>
        <p:txBody>
          <a:bodyPr/>
          <a:lstStyle>
            <a:lvl1pPr>
              <a:defRPr/>
            </a:lvl1pPr>
          </a:lstStyle>
          <a:p>
            <a:pPr>
              <a:defRPr/>
            </a:pPr>
            <a:fld id="{9AD0DC0B-E688-49A0-B4CF-6E9CEB7E360F}" type="slidenum">
              <a:rPr lang="it-IT"/>
              <a:pPr>
                <a:defRPr/>
              </a:pPr>
              <a:t>‹#›</a:t>
            </a:fld>
            <a:endParaRPr lang="it-IT"/>
          </a:p>
        </p:txBody>
      </p:sp>
    </p:spTree>
  </p:cSld>
  <p:clrMapOvr>
    <a:masterClrMapping/>
  </p:clrMapOvr>
  <p:transition>
    <p:zoom/>
  </p:transition>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58026" y="609600"/>
            <a:ext cx="2103438" cy="54864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744539" y="609600"/>
            <a:ext cx="6161087" cy="54864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it-IT"/>
          </a:p>
        </p:txBody>
      </p:sp>
      <p:sp>
        <p:nvSpPr>
          <p:cNvPr id="5" name="Rectangle 5"/>
          <p:cNvSpPr>
            <a:spLocks noGrp="1" noChangeArrowheads="1"/>
          </p:cNvSpPr>
          <p:nvPr>
            <p:ph type="ftr" sz="quarter" idx="11"/>
          </p:nvPr>
        </p:nvSpPr>
        <p:spPr>
          <a:ln/>
        </p:spPr>
        <p:txBody>
          <a:bodyPr/>
          <a:lstStyle>
            <a:lvl1pPr>
              <a:defRPr/>
            </a:lvl1pPr>
          </a:lstStyle>
          <a:p>
            <a:pPr>
              <a:defRPr/>
            </a:pPr>
            <a:endParaRPr lang="it-IT"/>
          </a:p>
        </p:txBody>
      </p:sp>
      <p:sp>
        <p:nvSpPr>
          <p:cNvPr id="6" name="Rectangle 6"/>
          <p:cNvSpPr>
            <a:spLocks noGrp="1" noChangeArrowheads="1"/>
          </p:cNvSpPr>
          <p:nvPr>
            <p:ph type="sldNum" sz="quarter" idx="12"/>
          </p:nvPr>
        </p:nvSpPr>
        <p:spPr>
          <a:ln/>
        </p:spPr>
        <p:txBody>
          <a:bodyPr/>
          <a:lstStyle>
            <a:lvl1pPr>
              <a:defRPr/>
            </a:lvl1pPr>
          </a:lstStyle>
          <a:p>
            <a:pPr>
              <a:defRPr/>
            </a:pPr>
            <a:fld id="{7023AA3E-DF17-4DEB-B1F9-624E08363FCF}" type="slidenum">
              <a:rPr lang="it-IT"/>
              <a:pPr>
                <a:defRPr/>
              </a:pPr>
              <a:t>‹#›</a:t>
            </a:fld>
            <a:endParaRPr lang="it-IT"/>
          </a:p>
        </p:txBody>
      </p:sp>
    </p:spTree>
  </p:cSld>
  <p:clrMapOvr>
    <a:masterClrMapping/>
  </p:clrMapOvr>
  <p:transition>
    <p:zoom/>
  </p:transition>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744539" y="609600"/>
            <a:ext cx="8416925" cy="1143000"/>
          </a:xfrm>
        </p:spPr>
        <p:txBody>
          <a:bodyPr/>
          <a:lstStyle/>
          <a:p>
            <a:r>
              <a:rPr lang="en-US"/>
              <a:t>Click to edit Master title style</a:t>
            </a:r>
          </a:p>
        </p:txBody>
      </p:sp>
      <p:sp>
        <p:nvSpPr>
          <p:cNvPr id="3" name="Content Placeholder 2"/>
          <p:cNvSpPr>
            <a:spLocks noGrp="1"/>
          </p:cNvSpPr>
          <p:nvPr>
            <p:ph sz="quarter" idx="1"/>
          </p:nvPr>
        </p:nvSpPr>
        <p:spPr>
          <a:xfrm>
            <a:off x="744538" y="1981200"/>
            <a:ext cx="4132262" cy="1981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quarter" idx="2"/>
          </p:nvPr>
        </p:nvSpPr>
        <p:spPr>
          <a:xfrm>
            <a:off x="5029201" y="1981200"/>
            <a:ext cx="4132263" cy="1981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Content Placeholder 4"/>
          <p:cNvSpPr>
            <a:spLocks noGrp="1"/>
          </p:cNvSpPr>
          <p:nvPr>
            <p:ph sz="quarter" idx="3"/>
          </p:nvPr>
        </p:nvSpPr>
        <p:spPr>
          <a:xfrm>
            <a:off x="744538" y="4114800"/>
            <a:ext cx="4132262" cy="1981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Content Placeholder 5"/>
          <p:cNvSpPr>
            <a:spLocks noGrp="1"/>
          </p:cNvSpPr>
          <p:nvPr>
            <p:ph sz="quarter" idx="4"/>
          </p:nvPr>
        </p:nvSpPr>
        <p:spPr>
          <a:xfrm>
            <a:off x="5029201" y="4114800"/>
            <a:ext cx="4132263" cy="1981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p:cNvSpPr>
            <a:spLocks noGrp="1" noChangeArrowheads="1"/>
          </p:cNvSpPr>
          <p:nvPr>
            <p:ph type="dt" sz="half" idx="10"/>
          </p:nvPr>
        </p:nvSpPr>
        <p:spPr>
          <a:ln/>
        </p:spPr>
        <p:txBody>
          <a:bodyPr/>
          <a:lstStyle>
            <a:lvl1pPr>
              <a:defRPr/>
            </a:lvl1pPr>
          </a:lstStyle>
          <a:p>
            <a:pPr>
              <a:defRPr/>
            </a:pPr>
            <a:endParaRPr lang="it-IT"/>
          </a:p>
        </p:txBody>
      </p:sp>
      <p:sp>
        <p:nvSpPr>
          <p:cNvPr id="8" name="Rectangle 5"/>
          <p:cNvSpPr>
            <a:spLocks noGrp="1" noChangeArrowheads="1"/>
          </p:cNvSpPr>
          <p:nvPr>
            <p:ph type="ftr" sz="quarter" idx="11"/>
          </p:nvPr>
        </p:nvSpPr>
        <p:spPr>
          <a:ln/>
        </p:spPr>
        <p:txBody>
          <a:bodyPr/>
          <a:lstStyle>
            <a:lvl1pPr>
              <a:defRPr/>
            </a:lvl1pPr>
          </a:lstStyle>
          <a:p>
            <a:pPr>
              <a:defRPr/>
            </a:pPr>
            <a:endParaRPr lang="it-IT"/>
          </a:p>
        </p:txBody>
      </p:sp>
      <p:sp>
        <p:nvSpPr>
          <p:cNvPr id="9" name="Rectangle 6"/>
          <p:cNvSpPr>
            <a:spLocks noGrp="1" noChangeArrowheads="1"/>
          </p:cNvSpPr>
          <p:nvPr>
            <p:ph type="sldNum" sz="quarter" idx="12"/>
          </p:nvPr>
        </p:nvSpPr>
        <p:spPr>
          <a:ln/>
        </p:spPr>
        <p:txBody>
          <a:bodyPr/>
          <a:lstStyle>
            <a:lvl1pPr>
              <a:defRPr/>
            </a:lvl1pPr>
          </a:lstStyle>
          <a:p>
            <a:pPr>
              <a:defRPr/>
            </a:pPr>
            <a:fld id="{3589CC5F-DB6E-4B69-8866-52D50687CC65}" type="slidenum">
              <a:rPr lang="it-IT"/>
              <a:pPr>
                <a:defRPr/>
              </a:pPr>
              <a:t>‹#›</a:t>
            </a:fld>
            <a:endParaRPr lang="it-IT"/>
          </a:p>
        </p:txBody>
      </p:sp>
    </p:spTree>
  </p:cSld>
  <p:clrMapOvr>
    <a:masterClrMapping/>
  </p:clrMapOvr>
  <p:transition>
    <p:zoom/>
  </p:transition>
</p:sldLayout>
</file>

<file path=ppt/slideLayouts/slideLayout13.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2" name="Title 1"/>
          <p:cNvSpPr>
            <a:spLocks noGrp="1"/>
          </p:cNvSpPr>
          <p:nvPr>
            <p:ph type="title"/>
          </p:nvPr>
        </p:nvSpPr>
        <p:spPr>
          <a:xfrm>
            <a:off x="744539" y="609600"/>
            <a:ext cx="8416925" cy="1143000"/>
          </a:xfrm>
        </p:spPr>
        <p:txBody>
          <a:bodyPr/>
          <a:lstStyle/>
          <a:p>
            <a:r>
              <a:rPr lang="en-US"/>
              <a:t>Click to edit Master title style</a:t>
            </a:r>
          </a:p>
        </p:txBody>
      </p:sp>
      <p:sp>
        <p:nvSpPr>
          <p:cNvPr id="3" name="Content Placeholder 2"/>
          <p:cNvSpPr>
            <a:spLocks noGrp="1"/>
          </p:cNvSpPr>
          <p:nvPr>
            <p:ph sz="half" idx="1"/>
          </p:nvPr>
        </p:nvSpPr>
        <p:spPr>
          <a:xfrm>
            <a:off x="744538" y="1981200"/>
            <a:ext cx="4132262" cy="4114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quarter" idx="2"/>
          </p:nvPr>
        </p:nvSpPr>
        <p:spPr>
          <a:xfrm>
            <a:off x="5029201" y="1981200"/>
            <a:ext cx="4132263" cy="1981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Content Placeholder 4"/>
          <p:cNvSpPr>
            <a:spLocks noGrp="1"/>
          </p:cNvSpPr>
          <p:nvPr>
            <p:ph sz="quarter" idx="3"/>
          </p:nvPr>
        </p:nvSpPr>
        <p:spPr>
          <a:xfrm>
            <a:off x="5029201" y="4114800"/>
            <a:ext cx="4132263" cy="1981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Rectangle 4"/>
          <p:cNvSpPr>
            <a:spLocks noGrp="1" noChangeArrowheads="1"/>
          </p:cNvSpPr>
          <p:nvPr>
            <p:ph type="dt" sz="half" idx="10"/>
          </p:nvPr>
        </p:nvSpPr>
        <p:spPr>
          <a:ln/>
        </p:spPr>
        <p:txBody>
          <a:bodyPr/>
          <a:lstStyle>
            <a:lvl1pPr>
              <a:defRPr/>
            </a:lvl1pPr>
          </a:lstStyle>
          <a:p>
            <a:pPr>
              <a:defRPr/>
            </a:pPr>
            <a:endParaRPr lang="it-IT"/>
          </a:p>
        </p:txBody>
      </p:sp>
      <p:sp>
        <p:nvSpPr>
          <p:cNvPr id="7" name="Rectangle 5"/>
          <p:cNvSpPr>
            <a:spLocks noGrp="1" noChangeArrowheads="1"/>
          </p:cNvSpPr>
          <p:nvPr>
            <p:ph type="ftr" sz="quarter" idx="11"/>
          </p:nvPr>
        </p:nvSpPr>
        <p:spPr>
          <a:ln/>
        </p:spPr>
        <p:txBody>
          <a:bodyPr/>
          <a:lstStyle>
            <a:lvl1pPr>
              <a:defRPr/>
            </a:lvl1pPr>
          </a:lstStyle>
          <a:p>
            <a:pPr>
              <a:defRPr/>
            </a:pPr>
            <a:endParaRPr lang="it-IT"/>
          </a:p>
        </p:txBody>
      </p:sp>
      <p:sp>
        <p:nvSpPr>
          <p:cNvPr id="8" name="Rectangle 6"/>
          <p:cNvSpPr>
            <a:spLocks noGrp="1" noChangeArrowheads="1"/>
          </p:cNvSpPr>
          <p:nvPr>
            <p:ph type="sldNum" sz="quarter" idx="12"/>
          </p:nvPr>
        </p:nvSpPr>
        <p:spPr>
          <a:ln/>
        </p:spPr>
        <p:txBody>
          <a:bodyPr/>
          <a:lstStyle>
            <a:lvl1pPr>
              <a:defRPr/>
            </a:lvl1pPr>
          </a:lstStyle>
          <a:p>
            <a:pPr>
              <a:defRPr/>
            </a:pPr>
            <a:fld id="{5AE2DDE3-F8F1-4680-8506-3886382C3116}" type="slidenum">
              <a:rPr lang="it-IT"/>
              <a:pPr>
                <a:defRPr/>
              </a:pPr>
              <a:t>‹#›</a:t>
            </a:fld>
            <a:endParaRPr lang="it-IT"/>
          </a:p>
        </p:txBody>
      </p:sp>
    </p:spTree>
  </p:cSld>
  <p:clrMapOvr>
    <a:masterClrMapping/>
  </p:clrMapOvr>
  <p:transition>
    <p:zoom/>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it-IT"/>
          </a:p>
        </p:txBody>
      </p:sp>
      <p:sp>
        <p:nvSpPr>
          <p:cNvPr id="5" name="Rectangle 5"/>
          <p:cNvSpPr>
            <a:spLocks noGrp="1" noChangeArrowheads="1"/>
          </p:cNvSpPr>
          <p:nvPr>
            <p:ph type="ftr" sz="quarter" idx="11"/>
          </p:nvPr>
        </p:nvSpPr>
        <p:spPr>
          <a:ln/>
        </p:spPr>
        <p:txBody>
          <a:bodyPr/>
          <a:lstStyle>
            <a:lvl1pPr>
              <a:defRPr/>
            </a:lvl1pPr>
          </a:lstStyle>
          <a:p>
            <a:pPr>
              <a:defRPr/>
            </a:pPr>
            <a:endParaRPr lang="it-IT"/>
          </a:p>
        </p:txBody>
      </p:sp>
      <p:sp>
        <p:nvSpPr>
          <p:cNvPr id="6" name="Rectangle 6"/>
          <p:cNvSpPr>
            <a:spLocks noGrp="1" noChangeArrowheads="1"/>
          </p:cNvSpPr>
          <p:nvPr>
            <p:ph type="sldNum" sz="quarter" idx="12"/>
          </p:nvPr>
        </p:nvSpPr>
        <p:spPr>
          <a:ln/>
        </p:spPr>
        <p:txBody>
          <a:bodyPr/>
          <a:lstStyle>
            <a:lvl1pPr>
              <a:defRPr/>
            </a:lvl1pPr>
          </a:lstStyle>
          <a:p>
            <a:pPr>
              <a:defRPr/>
            </a:pPr>
            <a:fld id="{B991B6A8-7030-42B6-9609-E10B75A01161}" type="slidenum">
              <a:rPr lang="it-IT"/>
              <a:pPr>
                <a:defRPr/>
              </a:pPr>
              <a:t>‹#›</a:t>
            </a:fld>
            <a:endParaRPr lang="it-IT"/>
          </a:p>
        </p:txBody>
      </p:sp>
    </p:spTree>
  </p:cSld>
  <p:clrMapOvr>
    <a:masterClrMapping/>
  </p:clrMapOvr>
  <p:transition>
    <p:zoom/>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82638" y="4406902"/>
            <a:ext cx="84201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82638" y="2906713"/>
            <a:ext cx="84201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endParaRPr lang="it-IT"/>
          </a:p>
        </p:txBody>
      </p:sp>
      <p:sp>
        <p:nvSpPr>
          <p:cNvPr id="5" name="Rectangle 5"/>
          <p:cNvSpPr>
            <a:spLocks noGrp="1" noChangeArrowheads="1"/>
          </p:cNvSpPr>
          <p:nvPr>
            <p:ph type="ftr" sz="quarter" idx="11"/>
          </p:nvPr>
        </p:nvSpPr>
        <p:spPr>
          <a:ln/>
        </p:spPr>
        <p:txBody>
          <a:bodyPr/>
          <a:lstStyle>
            <a:lvl1pPr>
              <a:defRPr/>
            </a:lvl1pPr>
          </a:lstStyle>
          <a:p>
            <a:pPr>
              <a:defRPr/>
            </a:pPr>
            <a:endParaRPr lang="it-IT"/>
          </a:p>
        </p:txBody>
      </p:sp>
      <p:sp>
        <p:nvSpPr>
          <p:cNvPr id="6" name="Rectangle 6"/>
          <p:cNvSpPr>
            <a:spLocks noGrp="1" noChangeArrowheads="1"/>
          </p:cNvSpPr>
          <p:nvPr>
            <p:ph type="sldNum" sz="quarter" idx="12"/>
          </p:nvPr>
        </p:nvSpPr>
        <p:spPr>
          <a:ln/>
        </p:spPr>
        <p:txBody>
          <a:bodyPr/>
          <a:lstStyle>
            <a:lvl1pPr>
              <a:defRPr/>
            </a:lvl1pPr>
          </a:lstStyle>
          <a:p>
            <a:pPr>
              <a:defRPr/>
            </a:pPr>
            <a:fld id="{CEBDA5E1-47D7-41A8-AFEE-45963765E09C}" type="slidenum">
              <a:rPr lang="it-IT"/>
              <a:pPr>
                <a:defRPr/>
              </a:pPr>
              <a:t>‹#›</a:t>
            </a:fld>
            <a:endParaRPr lang="it-IT"/>
          </a:p>
        </p:txBody>
      </p:sp>
    </p:spTree>
  </p:cSld>
  <p:clrMapOvr>
    <a:masterClrMapping/>
  </p:clrMapOvr>
  <p:transition>
    <p:zoom/>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744538" y="1981200"/>
            <a:ext cx="4132262"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5029201" y="1981200"/>
            <a:ext cx="4132263" cy="41148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p:cNvSpPr>
            <a:spLocks noGrp="1" noChangeArrowheads="1"/>
          </p:cNvSpPr>
          <p:nvPr>
            <p:ph type="dt" sz="half" idx="10"/>
          </p:nvPr>
        </p:nvSpPr>
        <p:spPr>
          <a:ln/>
        </p:spPr>
        <p:txBody>
          <a:bodyPr/>
          <a:lstStyle>
            <a:lvl1pPr>
              <a:defRPr/>
            </a:lvl1pPr>
          </a:lstStyle>
          <a:p>
            <a:pPr>
              <a:defRPr/>
            </a:pPr>
            <a:endParaRPr lang="it-IT"/>
          </a:p>
        </p:txBody>
      </p:sp>
      <p:sp>
        <p:nvSpPr>
          <p:cNvPr id="6" name="Rectangle 5"/>
          <p:cNvSpPr>
            <a:spLocks noGrp="1" noChangeArrowheads="1"/>
          </p:cNvSpPr>
          <p:nvPr>
            <p:ph type="ftr" sz="quarter" idx="11"/>
          </p:nvPr>
        </p:nvSpPr>
        <p:spPr>
          <a:ln/>
        </p:spPr>
        <p:txBody>
          <a:bodyPr/>
          <a:lstStyle>
            <a:lvl1pPr>
              <a:defRPr/>
            </a:lvl1pPr>
          </a:lstStyle>
          <a:p>
            <a:pPr>
              <a:defRPr/>
            </a:pPr>
            <a:endParaRPr lang="it-IT"/>
          </a:p>
        </p:txBody>
      </p:sp>
      <p:sp>
        <p:nvSpPr>
          <p:cNvPr id="7" name="Rectangle 6"/>
          <p:cNvSpPr>
            <a:spLocks noGrp="1" noChangeArrowheads="1"/>
          </p:cNvSpPr>
          <p:nvPr>
            <p:ph type="sldNum" sz="quarter" idx="12"/>
          </p:nvPr>
        </p:nvSpPr>
        <p:spPr>
          <a:ln/>
        </p:spPr>
        <p:txBody>
          <a:bodyPr/>
          <a:lstStyle>
            <a:lvl1pPr>
              <a:defRPr/>
            </a:lvl1pPr>
          </a:lstStyle>
          <a:p>
            <a:pPr>
              <a:defRPr/>
            </a:pPr>
            <a:fld id="{59F0AB44-9D16-44DF-8590-9492D8FF7E4F}" type="slidenum">
              <a:rPr lang="it-IT"/>
              <a:pPr>
                <a:defRPr/>
              </a:pPr>
              <a:t>‹#›</a:t>
            </a:fld>
            <a:endParaRPr lang="it-IT"/>
          </a:p>
        </p:txBody>
      </p:sp>
    </p:spTree>
  </p:cSld>
  <p:clrMapOvr>
    <a:masterClrMapping/>
  </p:clrMapOvr>
  <p:transition>
    <p:zoom/>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95300" y="274638"/>
            <a:ext cx="89154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95300" y="1535113"/>
            <a:ext cx="437673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95300" y="2174875"/>
            <a:ext cx="437673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5032377" y="1535113"/>
            <a:ext cx="437832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032377" y="2174875"/>
            <a:ext cx="437832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p:cNvSpPr>
            <a:spLocks noGrp="1" noChangeArrowheads="1"/>
          </p:cNvSpPr>
          <p:nvPr>
            <p:ph type="dt" sz="half" idx="10"/>
          </p:nvPr>
        </p:nvSpPr>
        <p:spPr>
          <a:ln/>
        </p:spPr>
        <p:txBody>
          <a:bodyPr/>
          <a:lstStyle>
            <a:lvl1pPr>
              <a:defRPr/>
            </a:lvl1pPr>
          </a:lstStyle>
          <a:p>
            <a:pPr>
              <a:defRPr/>
            </a:pPr>
            <a:endParaRPr lang="it-IT"/>
          </a:p>
        </p:txBody>
      </p:sp>
      <p:sp>
        <p:nvSpPr>
          <p:cNvPr id="8" name="Rectangle 5"/>
          <p:cNvSpPr>
            <a:spLocks noGrp="1" noChangeArrowheads="1"/>
          </p:cNvSpPr>
          <p:nvPr>
            <p:ph type="ftr" sz="quarter" idx="11"/>
          </p:nvPr>
        </p:nvSpPr>
        <p:spPr>
          <a:ln/>
        </p:spPr>
        <p:txBody>
          <a:bodyPr/>
          <a:lstStyle>
            <a:lvl1pPr>
              <a:defRPr/>
            </a:lvl1pPr>
          </a:lstStyle>
          <a:p>
            <a:pPr>
              <a:defRPr/>
            </a:pPr>
            <a:endParaRPr lang="it-IT"/>
          </a:p>
        </p:txBody>
      </p:sp>
      <p:sp>
        <p:nvSpPr>
          <p:cNvPr id="9" name="Rectangle 6"/>
          <p:cNvSpPr>
            <a:spLocks noGrp="1" noChangeArrowheads="1"/>
          </p:cNvSpPr>
          <p:nvPr>
            <p:ph type="sldNum" sz="quarter" idx="12"/>
          </p:nvPr>
        </p:nvSpPr>
        <p:spPr>
          <a:ln/>
        </p:spPr>
        <p:txBody>
          <a:bodyPr/>
          <a:lstStyle>
            <a:lvl1pPr>
              <a:defRPr/>
            </a:lvl1pPr>
          </a:lstStyle>
          <a:p>
            <a:pPr>
              <a:defRPr/>
            </a:pPr>
            <a:fld id="{78CAB66A-0FC9-444A-8EE8-500F0AAAE9F9}" type="slidenum">
              <a:rPr lang="it-IT"/>
              <a:pPr>
                <a:defRPr/>
              </a:pPr>
              <a:t>‹#›</a:t>
            </a:fld>
            <a:endParaRPr lang="it-IT"/>
          </a:p>
        </p:txBody>
      </p:sp>
    </p:spTree>
  </p:cSld>
  <p:clrMapOvr>
    <a:masterClrMapping/>
  </p:clrMapOvr>
  <p:transition>
    <p:zoom/>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p:cNvSpPr>
            <a:spLocks noGrp="1" noChangeArrowheads="1"/>
          </p:cNvSpPr>
          <p:nvPr>
            <p:ph type="dt" sz="half" idx="10"/>
          </p:nvPr>
        </p:nvSpPr>
        <p:spPr>
          <a:ln/>
        </p:spPr>
        <p:txBody>
          <a:bodyPr/>
          <a:lstStyle>
            <a:lvl1pPr>
              <a:defRPr/>
            </a:lvl1pPr>
          </a:lstStyle>
          <a:p>
            <a:pPr>
              <a:defRPr/>
            </a:pPr>
            <a:endParaRPr lang="it-IT"/>
          </a:p>
        </p:txBody>
      </p:sp>
      <p:sp>
        <p:nvSpPr>
          <p:cNvPr id="4" name="Rectangle 5"/>
          <p:cNvSpPr>
            <a:spLocks noGrp="1" noChangeArrowheads="1"/>
          </p:cNvSpPr>
          <p:nvPr>
            <p:ph type="ftr" sz="quarter" idx="11"/>
          </p:nvPr>
        </p:nvSpPr>
        <p:spPr>
          <a:ln/>
        </p:spPr>
        <p:txBody>
          <a:bodyPr/>
          <a:lstStyle>
            <a:lvl1pPr>
              <a:defRPr/>
            </a:lvl1pPr>
          </a:lstStyle>
          <a:p>
            <a:pPr>
              <a:defRPr/>
            </a:pPr>
            <a:endParaRPr lang="it-IT"/>
          </a:p>
        </p:txBody>
      </p:sp>
      <p:sp>
        <p:nvSpPr>
          <p:cNvPr id="5" name="Rectangle 6"/>
          <p:cNvSpPr>
            <a:spLocks noGrp="1" noChangeArrowheads="1"/>
          </p:cNvSpPr>
          <p:nvPr>
            <p:ph type="sldNum" sz="quarter" idx="12"/>
          </p:nvPr>
        </p:nvSpPr>
        <p:spPr>
          <a:ln/>
        </p:spPr>
        <p:txBody>
          <a:bodyPr/>
          <a:lstStyle>
            <a:lvl1pPr>
              <a:defRPr/>
            </a:lvl1pPr>
          </a:lstStyle>
          <a:p>
            <a:pPr>
              <a:defRPr/>
            </a:pPr>
            <a:fld id="{808C483B-B30E-47C3-8C15-AF84B9FCC98B}" type="slidenum">
              <a:rPr lang="it-IT"/>
              <a:pPr>
                <a:defRPr/>
              </a:pPr>
              <a:t>‹#›</a:t>
            </a:fld>
            <a:endParaRPr lang="it-IT"/>
          </a:p>
        </p:txBody>
      </p:sp>
    </p:spTree>
  </p:cSld>
  <p:clrMapOvr>
    <a:masterClrMapping/>
  </p:clrMapOvr>
  <p:transition>
    <p:zoom/>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it-IT"/>
          </a:p>
        </p:txBody>
      </p:sp>
      <p:sp>
        <p:nvSpPr>
          <p:cNvPr id="3" name="Rectangle 5"/>
          <p:cNvSpPr>
            <a:spLocks noGrp="1" noChangeArrowheads="1"/>
          </p:cNvSpPr>
          <p:nvPr>
            <p:ph type="ftr" sz="quarter" idx="11"/>
          </p:nvPr>
        </p:nvSpPr>
        <p:spPr>
          <a:ln/>
        </p:spPr>
        <p:txBody>
          <a:bodyPr/>
          <a:lstStyle>
            <a:lvl1pPr>
              <a:defRPr/>
            </a:lvl1pPr>
          </a:lstStyle>
          <a:p>
            <a:pPr>
              <a:defRPr/>
            </a:pPr>
            <a:endParaRPr lang="it-IT"/>
          </a:p>
        </p:txBody>
      </p:sp>
      <p:sp>
        <p:nvSpPr>
          <p:cNvPr id="4" name="Rectangle 6"/>
          <p:cNvSpPr>
            <a:spLocks noGrp="1" noChangeArrowheads="1"/>
          </p:cNvSpPr>
          <p:nvPr>
            <p:ph type="sldNum" sz="quarter" idx="12"/>
          </p:nvPr>
        </p:nvSpPr>
        <p:spPr>
          <a:ln/>
        </p:spPr>
        <p:txBody>
          <a:bodyPr/>
          <a:lstStyle>
            <a:lvl1pPr>
              <a:defRPr/>
            </a:lvl1pPr>
          </a:lstStyle>
          <a:p>
            <a:pPr>
              <a:defRPr/>
            </a:pPr>
            <a:fld id="{2CF809B6-5854-4D50-BF2B-470F7C7333C2}" type="slidenum">
              <a:rPr lang="it-IT"/>
              <a:pPr>
                <a:defRPr/>
              </a:pPr>
              <a:t>‹#›</a:t>
            </a:fld>
            <a:endParaRPr lang="it-IT"/>
          </a:p>
        </p:txBody>
      </p:sp>
    </p:spTree>
  </p:cSld>
  <p:clrMapOvr>
    <a:masterClrMapping/>
  </p:clrMapOvr>
  <p:transition>
    <p:zoom/>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301" y="273050"/>
            <a:ext cx="3259138"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873499" y="273052"/>
            <a:ext cx="5537201"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95301" y="1435102"/>
            <a:ext cx="3259138"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it-IT"/>
          </a:p>
        </p:txBody>
      </p:sp>
      <p:sp>
        <p:nvSpPr>
          <p:cNvPr id="6" name="Rectangle 5"/>
          <p:cNvSpPr>
            <a:spLocks noGrp="1" noChangeArrowheads="1"/>
          </p:cNvSpPr>
          <p:nvPr>
            <p:ph type="ftr" sz="quarter" idx="11"/>
          </p:nvPr>
        </p:nvSpPr>
        <p:spPr>
          <a:ln/>
        </p:spPr>
        <p:txBody>
          <a:bodyPr/>
          <a:lstStyle>
            <a:lvl1pPr>
              <a:defRPr/>
            </a:lvl1pPr>
          </a:lstStyle>
          <a:p>
            <a:pPr>
              <a:defRPr/>
            </a:pPr>
            <a:endParaRPr lang="it-IT"/>
          </a:p>
        </p:txBody>
      </p:sp>
      <p:sp>
        <p:nvSpPr>
          <p:cNvPr id="7" name="Rectangle 6"/>
          <p:cNvSpPr>
            <a:spLocks noGrp="1" noChangeArrowheads="1"/>
          </p:cNvSpPr>
          <p:nvPr>
            <p:ph type="sldNum" sz="quarter" idx="12"/>
          </p:nvPr>
        </p:nvSpPr>
        <p:spPr>
          <a:ln/>
        </p:spPr>
        <p:txBody>
          <a:bodyPr/>
          <a:lstStyle>
            <a:lvl1pPr>
              <a:defRPr/>
            </a:lvl1pPr>
          </a:lstStyle>
          <a:p>
            <a:pPr>
              <a:defRPr/>
            </a:pPr>
            <a:fld id="{0F7B5D72-ECA1-4398-8836-01D5B6742C86}" type="slidenum">
              <a:rPr lang="it-IT"/>
              <a:pPr>
                <a:defRPr/>
              </a:pPr>
              <a:t>‹#›</a:t>
            </a:fld>
            <a:endParaRPr lang="it-IT"/>
          </a:p>
        </p:txBody>
      </p:sp>
    </p:spTree>
  </p:cSld>
  <p:clrMapOvr>
    <a:masterClrMapping/>
  </p:clrMapOvr>
  <p:transition>
    <p:zoom/>
  </p:transition>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941513" y="4800600"/>
            <a:ext cx="59436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941513"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941513"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it-IT"/>
          </a:p>
        </p:txBody>
      </p:sp>
      <p:sp>
        <p:nvSpPr>
          <p:cNvPr id="6" name="Rectangle 5"/>
          <p:cNvSpPr>
            <a:spLocks noGrp="1" noChangeArrowheads="1"/>
          </p:cNvSpPr>
          <p:nvPr>
            <p:ph type="ftr" sz="quarter" idx="11"/>
          </p:nvPr>
        </p:nvSpPr>
        <p:spPr>
          <a:ln/>
        </p:spPr>
        <p:txBody>
          <a:bodyPr/>
          <a:lstStyle>
            <a:lvl1pPr>
              <a:defRPr/>
            </a:lvl1pPr>
          </a:lstStyle>
          <a:p>
            <a:pPr>
              <a:defRPr/>
            </a:pPr>
            <a:endParaRPr lang="it-IT"/>
          </a:p>
        </p:txBody>
      </p:sp>
      <p:sp>
        <p:nvSpPr>
          <p:cNvPr id="7" name="Rectangle 6"/>
          <p:cNvSpPr>
            <a:spLocks noGrp="1" noChangeArrowheads="1"/>
          </p:cNvSpPr>
          <p:nvPr>
            <p:ph type="sldNum" sz="quarter" idx="12"/>
          </p:nvPr>
        </p:nvSpPr>
        <p:spPr>
          <a:ln/>
        </p:spPr>
        <p:txBody>
          <a:bodyPr/>
          <a:lstStyle>
            <a:lvl1pPr>
              <a:defRPr/>
            </a:lvl1pPr>
          </a:lstStyle>
          <a:p>
            <a:pPr>
              <a:defRPr/>
            </a:pPr>
            <a:fld id="{5DB755E2-169C-4002-9D4B-D6224E9D25FB}" type="slidenum">
              <a:rPr lang="it-IT"/>
              <a:pPr>
                <a:defRPr/>
              </a:pPr>
              <a:t>‹#›</a:t>
            </a:fld>
            <a:endParaRPr lang="it-IT"/>
          </a:p>
        </p:txBody>
      </p:sp>
    </p:spTree>
  </p:cSld>
  <p:clrMapOvr>
    <a:masterClrMapping/>
  </p:clrMapOvr>
  <p:transition>
    <p:zoom/>
  </p:transition>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744539" y="609600"/>
            <a:ext cx="8416925" cy="1143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it-IT"/>
              <a:t>Fare clic per modificare lo stile del titolo dello schema</a:t>
            </a:r>
          </a:p>
        </p:txBody>
      </p:sp>
      <p:sp>
        <p:nvSpPr>
          <p:cNvPr id="1027" name="Rectangle 3"/>
          <p:cNvSpPr>
            <a:spLocks noGrp="1" noChangeArrowheads="1"/>
          </p:cNvSpPr>
          <p:nvPr>
            <p:ph type="body" idx="1"/>
          </p:nvPr>
        </p:nvSpPr>
        <p:spPr bwMode="auto">
          <a:xfrm>
            <a:off x="744539" y="1981200"/>
            <a:ext cx="8416925" cy="41148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1028" name="Rectangle 4"/>
          <p:cNvSpPr>
            <a:spLocks noGrp="1" noChangeArrowheads="1"/>
          </p:cNvSpPr>
          <p:nvPr>
            <p:ph type="dt" sz="half" idx="2"/>
          </p:nvPr>
        </p:nvSpPr>
        <p:spPr bwMode="auto">
          <a:xfrm>
            <a:off x="744538" y="6248400"/>
            <a:ext cx="206375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l">
              <a:defRPr sz="1400" b="0">
                <a:cs typeface="+mn-cs"/>
              </a:defRPr>
            </a:lvl1pPr>
          </a:lstStyle>
          <a:p>
            <a:pPr>
              <a:defRPr/>
            </a:pPr>
            <a:endParaRPr lang="it-IT"/>
          </a:p>
        </p:txBody>
      </p:sp>
      <p:sp>
        <p:nvSpPr>
          <p:cNvPr id="1029" name="Rectangle 5"/>
          <p:cNvSpPr>
            <a:spLocks noGrp="1" noChangeArrowheads="1"/>
          </p:cNvSpPr>
          <p:nvPr>
            <p:ph type="ftr" sz="quarter" idx="3"/>
          </p:nvPr>
        </p:nvSpPr>
        <p:spPr bwMode="auto">
          <a:xfrm>
            <a:off x="3382964" y="6248400"/>
            <a:ext cx="3140075"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ctr">
              <a:defRPr sz="1400" b="0">
                <a:cs typeface="+mn-cs"/>
              </a:defRPr>
            </a:lvl1pPr>
          </a:lstStyle>
          <a:p>
            <a:pPr>
              <a:defRPr/>
            </a:pPr>
            <a:endParaRPr lang="it-IT"/>
          </a:p>
        </p:txBody>
      </p:sp>
      <p:sp>
        <p:nvSpPr>
          <p:cNvPr id="1030" name="Rectangle 6"/>
          <p:cNvSpPr>
            <a:spLocks noGrp="1" noChangeArrowheads="1"/>
          </p:cNvSpPr>
          <p:nvPr>
            <p:ph type="sldNum" sz="quarter" idx="4"/>
          </p:nvPr>
        </p:nvSpPr>
        <p:spPr bwMode="auto">
          <a:xfrm>
            <a:off x="7097713" y="6248400"/>
            <a:ext cx="206375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400" b="0">
                <a:cs typeface="+mn-cs"/>
              </a:defRPr>
            </a:lvl1pPr>
          </a:lstStyle>
          <a:p>
            <a:pPr>
              <a:defRPr/>
            </a:pPr>
            <a:fld id="{F953409B-4A7D-425B-B2BB-BD24375ACEBD}" type="slidenum">
              <a:rPr lang="it-IT"/>
              <a:pPr>
                <a:defRPr/>
              </a:pPr>
              <a:t>‹#›</a:t>
            </a:fld>
            <a:endParaRPr lang="it-IT"/>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Lst>
  <p:transition>
    <p:zoom/>
  </p:transition>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Times New Roman" pitchFamily="18" charset="0"/>
        </a:defRPr>
      </a:lvl2pPr>
      <a:lvl3pPr algn="ctr" rtl="0" eaLnBrk="0" fontAlgn="base" hangingPunct="0">
        <a:spcBef>
          <a:spcPct val="0"/>
        </a:spcBef>
        <a:spcAft>
          <a:spcPct val="0"/>
        </a:spcAft>
        <a:defRPr sz="4400">
          <a:solidFill>
            <a:schemeClr val="tx2"/>
          </a:solidFill>
          <a:latin typeface="Times New Roman" pitchFamily="18" charset="0"/>
        </a:defRPr>
      </a:lvl3pPr>
      <a:lvl4pPr algn="ctr" rtl="0" eaLnBrk="0" fontAlgn="base" hangingPunct="0">
        <a:spcBef>
          <a:spcPct val="0"/>
        </a:spcBef>
        <a:spcAft>
          <a:spcPct val="0"/>
        </a:spcAft>
        <a:defRPr sz="4400">
          <a:solidFill>
            <a:schemeClr val="tx2"/>
          </a:solidFill>
          <a:latin typeface="Times New Roman" pitchFamily="18" charset="0"/>
        </a:defRPr>
      </a:lvl4pPr>
      <a:lvl5pPr algn="ctr" rtl="0" eaLnBrk="0" fontAlgn="base" hangingPunct="0">
        <a:spcBef>
          <a:spcPct val="0"/>
        </a:spcBef>
        <a:spcAft>
          <a:spcPct val="0"/>
        </a:spcAft>
        <a:defRPr sz="4400">
          <a:solidFill>
            <a:schemeClr val="tx2"/>
          </a:solidFill>
          <a:latin typeface="Times New Roman" pitchFamily="18" charset="0"/>
        </a:defRPr>
      </a:lvl5pPr>
      <a:lvl6pPr marL="457200" algn="ctr" rtl="0" fontAlgn="base">
        <a:spcBef>
          <a:spcPct val="0"/>
        </a:spcBef>
        <a:spcAft>
          <a:spcPct val="0"/>
        </a:spcAft>
        <a:defRPr sz="4400">
          <a:solidFill>
            <a:schemeClr val="tx2"/>
          </a:solidFill>
          <a:latin typeface="Times New Roman" pitchFamily="18" charset="0"/>
        </a:defRPr>
      </a:lvl6pPr>
      <a:lvl7pPr marL="914400" algn="ctr" rtl="0" fontAlgn="base">
        <a:spcBef>
          <a:spcPct val="0"/>
        </a:spcBef>
        <a:spcAft>
          <a:spcPct val="0"/>
        </a:spcAft>
        <a:defRPr sz="4400">
          <a:solidFill>
            <a:schemeClr val="tx2"/>
          </a:solidFill>
          <a:latin typeface="Times New Roman" pitchFamily="18" charset="0"/>
        </a:defRPr>
      </a:lvl7pPr>
      <a:lvl8pPr marL="1371600" algn="ctr" rtl="0" fontAlgn="base">
        <a:spcBef>
          <a:spcPct val="0"/>
        </a:spcBef>
        <a:spcAft>
          <a:spcPct val="0"/>
        </a:spcAft>
        <a:defRPr sz="4400">
          <a:solidFill>
            <a:schemeClr val="tx2"/>
          </a:solidFill>
          <a:latin typeface="Times New Roman" pitchFamily="18" charset="0"/>
        </a:defRPr>
      </a:lvl8pPr>
      <a:lvl9pPr marL="1828800" algn="ctr" rtl="0" fontAlgn="base">
        <a:spcBef>
          <a:spcPct val="0"/>
        </a:spcBef>
        <a:spcAft>
          <a:spcPct val="0"/>
        </a:spcAft>
        <a:defRPr sz="4400">
          <a:solidFill>
            <a:schemeClr val="tx2"/>
          </a:solidFill>
          <a:latin typeface="Times New Roman" pitchFamily="18"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defRPr>
      </a:lvl2pPr>
      <a:lvl3pPr marL="1143000" indent="-228600" algn="l" rtl="0" eaLnBrk="0" fontAlgn="base" hangingPunct="0">
        <a:spcBef>
          <a:spcPct val="20000"/>
        </a:spcBef>
        <a:spcAft>
          <a:spcPct val="0"/>
        </a:spcAft>
        <a:buChar char="•"/>
        <a:defRPr sz="2400">
          <a:solidFill>
            <a:schemeClr val="tx1"/>
          </a:solidFill>
          <a:latin typeface="+mn-lt"/>
        </a:defRPr>
      </a:lvl3pPr>
      <a:lvl4pPr marL="1600200" indent="-228600" algn="l" rtl="0" eaLnBrk="0" fontAlgn="base" hangingPunct="0">
        <a:spcBef>
          <a:spcPct val="20000"/>
        </a:spcBef>
        <a:spcAft>
          <a:spcPct val="0"/>
        </a:spcAft>
        <a:buChar char="–"/>
        <a:defRPr sz="2000">
          <a:solidFill>
            <a:schemeClr val="tx1"/>
          </a:solidFill>
          <a:latin typeface="+mn-lt"/>
        </a:defRPr>
      </a:lvl4pPr>
      <a:lvl5pPr marL="2057400" indent="-228600" algn="l" rtl="0" eaLnBrk="0" fontAlgn="base" hangingPunct="0">
        <a:spcBef>
          <a:spcPct val="20000"/>
        </a:spcBef>
        <a:spcAft>
          <a:spcPct val="0"/>
        </a:spcAft>
        <a:buChar char="»"/>
        <a:defRPr sz="2000">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openxmlformats.org/officeDocument/2006/relationships/video" Target="../media/media1.mp4"/><Relationship Id="rId1" Type="http://schemas.microsoft.com/office/2007/relationships/media" Target="../media/media1.mp4"/><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thermal with centre of mass track">
            <a:hlinkClick r:id="" action="ppaction://media"/>
            <a:extLst>
              <a:ext uri="{FF2B5EF4-FFF2-40B4-BE49-F238E27FC236}">
                <a16:creationId xmlns:a16="http://schemas.microsoft.com/office/drawing/2014/main" id="{57959641-B2B4-4B71-A295-5D1E5D7C3C78}"/>
              </a:ext>
            </a:extLst>
          </p:cNvPr>
          <p:cNvPicPr>
            <a:picLocks noChangeAspect="1"/>
          </p:cNvPicPr>
          <p:nvPr>
            <a:videoFile r:link="rId2"/>
            <p:extLst>
              <p:ext uri="{DAA4B4D4-6D71-4841-9C94-3DE7FCFB9230}">
                <p14:media xmlns:p14="http://schemas.microsoft.com/office/powerpoint/2010/main" r:embed="rId1"/>
              </p:ext>
            </p:extLst>
          </p:nvPr>
        </p:nvPicPr>
        <p:blipFill rotWithShape="1">
          <a:blip r:embed="rId4"/>
          <a:srcRect l="8387" t="24135" r="6814" b="6137"/>
          <a:stretch/>
        </p:blipFill>
        <p:spPr>
          <a:xfrm rot="10800000" flipH="1">
            <a:off x="2373211" y="2367326"/>
            <a:ext cx="4873452" cy="4246345"/>
          </a:xfrm>
          <a:prstGeom prst="rect">
            <a:avLst/>
          </a:prstGeom>
        </p:spPr>
      </p:pic>
      <p:sp>
        <p:nvSpPr>
          <p:cNvPr id="3" name="Title 1">
            <a:extLst>
              <a:ext uri="{FF2B5EF4-FFF2-40B4-BE49-F238E27FC236}">
                <a16:creationId xmlns:a16="http://schemas.microsoft.com/office/drawing/2014/main" id="{33C9DBC5-339C-4CB5-BEF5-5B80D2697E1F}"/>
              </a:ext>
            </a:extLst>
          </p:cNvPr>
          <p:cNvSpPr txBox="1">
            <a:spLocks/>
          </p:cNvSpPr>
          <p:nvPr/>
        </p:nvSpPr>
        <p:spPr>
          <a:xfrm>
            <a:off x="441789" y="214401"/>
            <a:ext cx="9072081" cy="1018498"/>
          </a:xfrm>
          <a:prstGeom prst="rect">
            <a:avLst/>
          </a:prstGeom>
        </p:spPr>
        <p:txBody>
          <a:bodyP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Times New Roman" pitchFamily="18" charset="0"/>
              </a:defRPr>
            </a:lvl2pPr>
            <a:lvl3pPr algn="ctr" rtl="0" eaLnBrk="0" fontAlgn="base" hangingPunct="0">
              <a:spcBef>
                <a:spcPct val="0"/>
              </a:spcBef>
              <a:spcAft>
                <a:spcPct val="0"/>
              </a:spcAft>
              <a:defRPr sz="4400">
                <a:solidFill>
                  <a:schemeClr val="tx2"/>
                </a:solidFill>
                <a:latin typeface="Times New Roman" pitchFamily="18" charset="0"/>
              </a:defRPr>
            </a:lvl3pPr>
            <a:lvl4pPr algn="ctr" rtl="0" eaLnBrk="0" fontAlgn="base" hangingPunct="0">
              <a:spcBef>
                <a:spcPct val="0"/>
              </a:spcBef>
              <a:spcAft>
                <a:spcPct val="0"/>
              </a:spcAft>
              <a:defRPr sz="4400">
                <a:solidFill>
                  <a:schemeClr val="tx2"/>
                </a:solidFill>
                <a:latin typeface="Times New Roman" pitchFamily="18" charset="0"/>
              </a:defRPr>
            </a:lvl4pPr>
            <a:lvl5pPr algn="ctr" rtl="0" eaLnBrk="0" fontAlgn="base" hangingPunct="0">
              <a:spcBef>
                <a:spcPct val="0"/>
              </a:spcBef>
              <a:spcAft>
                <a:spcPct val="0"/>
              </a:spcAft>
              <a:defRPr sz="4400">
                <a:solidFill>
                  <a:schemeClr val="tx2"/>
                </a:solidFill>
                <a:latin typeface="Times New Roman" pitchFamily="18" charset="0"/>
              </a:defRPr>
            </a:lvl5pPr>
            <a:lvl6pPr marL="457200" algn="ctr" rtl="0" fontAlgn="base">
              <a:spcBef>
                <a:spcPct val="0"/>
              </a:spcBef>
              <a:spcAft>
                <a:spcPct val="0"/>
              </a:spcAft>
              <a:defRPr sz="4400">
                <a:solidFill>
                  <a:schemeClr val="tx2"/>
                </a:solidFill>
                <a:latin typeface="Times New Roman" pitchFamily="18" charset="0"/>
              </a:defRPr>
            </a:lvl6pPr>
            <a:lvl7pPr marL="914400" algn="ctr" rtl="0" fontAlgn="base">
              <a:spcBef>
                <a:spcPct val="0"/>
              </a:spcBef>
              <a:spcAft>
                <a:spcPct val="0"/>
              </a:spcAft>
              <a:defRPr sz="4400">
                <a:solidFill>
                  <a:schemeClr val="tx2"/>
                </a:solidFill>
                <a:latin typeface="Times New Roman" pitchFamily="18" charset="0"/>
              </a:defRPr>
            </a:lvl7pPr>
            <a:lvl8pPr marL="1371600" algn="ctr" rtl="0" fontAlgn="base">
              <a:spcBef>
                <a:spcPct val="0"/>
              </a:spcBef>
              <a:spcAft>
                <a:spcPct val="0"/>
              </a:spcAft>
              <a:defRPr sz="4400">
                <a:solidFill>
                  <a:schemeClr val="tx2"/>
                </a:solidFill>
                <a:latin typeface="Times New Roman" pitchFamily="18" charset="0"/>
              </a:defRPr>
            </a:lvl8pPr>
            <a:lvl9pPr marL="1828800" algn="ctr" rtl="0" fontAlgn="base">
              <a:spcBef>
                <a:spcPct val="0"/>
              </a:spcBef>
              <a:spcAft>
                <a:spcPct val="0"/>
              </a:spcAft>
              <a:defRPr sz="4400">
                <a:solidFill>
                  <a:schemeClr val="tx2"/>
                </a:solidFill>
                <a:latin typeface="Times New Roman" pitchFamily="18" charset="0"/>
              </a:defRPr>
            </a:lvl9pPr>
          </a:lstStyle>
          <a:p>
            <a:r>
              <a:rPr lang="en-GB" sz="3200" kern="0" dirty="0">
                <a:latin typeface="Calibri Light" panose="020F0302020204030204" pitchFamily="34" charset="0"/>
                <a:cs typeface="Calibri Light" panose="020F0302020204030204" pitchFamily="34" charset="0"/>
              </a:rPr>
              <a:t>Random movements of a neutrophil in the absence of chemoattractant gradient </a:t>
            </a:r>
          </a:p>
          <a:p>
            <a:r>
              <a:rPr lang="en-GB" sz="1800" kern="0">
                <a:latin typeface="Calibri Light" panose="020F0302020204030204" pitchFamily="34" charset="0"/>
                <a:cs typeface="Calibri Light" panose="020F0302020204030204" pitchFamily="34" charset="0"/>
              </a:rPr>
              <a:t>Calcium level </a:t>
            </a:r>
            <a:r>
              <a:rPr lang="en-GB" sz="1800" kern="0" dirty="0">
                <a:latin typeface="Calibri Light" panose="020F0302020204030204" pitchFamily="34" charset="0"/>
                <a:cs typeface="Calibri Light" panose="020F0302020204030204" pitchFamily="34" charset="0"/>
              </a:rPr>
              <a:t>in a single neutrophil in the absence of chemoattractant imaged using fura2 as described in Methods. Note the significant delay between reversal of direction of calcium pulse and reversal of direction of movement.</a:t>
            </a:r>
          </a:p>
        </p:txBody>
      </p:sp>
    </p:spTree>
    <p:extLst>
      <p:ext uri="{BB962C8B-B14F-4D97-AF65-F5344CB8AC3E}">
        <p14:creationId xmlns:p14="http://schemas.microsoft.com/office/powerpoint/2010/main" val="879679908"/>
      </p:ext>
    </p:extLst>
  </p:cSld>
  <p:clrMapOvr>
    <a:masterClrMapping/>
  </p:clrMapOvr>
  <p:transition>
    <p:zoom/>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4000"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seq concurrent="1" nextAc="seek">
              <p:cTn id="7" restart="whenNotActive" fill="hold" evtFilter="cancelBubble" nodeType="interactiveSeq">
                <p:stCondLst>
                  <p:cond evt="onClick" delay="0">
                    <p:tgtEl>
                      <p:spTgt spid="2"/>
                    </p:tgtEl>
                  </p:cond>
                </p:stCondLst>
                <p:endSync evt="end" delay="0">
                  <p:rtn val="all"/>
                </p:endSync>
                <p:childTnLst>
                  <p:par>
                    <p:cTn id="8" fill="hold">
                      <p:stCondLst>
                        <p:cond delay="0"/>
                      </p:stCondLst>
                      <p:childTnLst>
                        <p:par>
                          <p:cTn id="9" fill="hold">
                            <p:stCondLst>
                              <p:cond delay="0"/>
                            </p:stCondLst>
                            <p:childTnLst>
                              <p:par>
                                <p:cTn id="10" presetID="2" presetClass="mediacall" presetSubtype="0" fill="hold" nodeType="clickEffect">
                                  <p:stCondLst>
                                    <p:cond delay="0"/>
                                  </p:stCondLst>
                                  <p:childTnLst>
                                    <p:cmd type="call" cmd="togglePause">
                                      <p:cBhvr>
                                        <p:cTn id="11" dur="1" fill="hold"/>
                                        <p:tgtEl>
                                          <p:spTgt spid="2"/>
                                        </p:tgtEl>
                                      </p:cBhvr>
                                    </p:cmd>
                                  </p:childTnLst>
                                </p:cTn>
                              </p:par>
                            </p:childTnLst>
                          </p:cTn>
                        </p:par>
                      </p:childTnLst>
                    </p:cTn>
                  </p:par>
                </p:childTnLst>
              </p:cTn>
              <p:nextCondLst>
                <p:cond evt="onClick" delay="0">
                  <p:tgtEl>
                    <p:spTgt spid="2"/>
                  </p:tgtEl>
                </p:cond>
              </p:nextCondLst>
            </p:seq>
            <p:video>
              <p:cMediaNode vol="80000">
                <p:cTn id="12" fill="hold" display="0">
                  <p:stCondLst>
                    <p:cond delay="indefinite"/>
                  </p:stCondLst>
                </p:cTn>
                <p:tgtEl>
                  <p:spTgt spid="2"/>
                </p:tgtEl>
              </p:cMediaNode>
            </p:video>
          </p:childTnLst>
        </p:cTn>
      </p:par>
    </p:tnLst>
  </p:timing>
</p:sld>
</file>

<file path=ppt/theme/theme1.xml><?xml version="1.0" encoding="utf-8"?>
<a:theme xmlns:a="http://schemas.openxmlformats.org/drawingml/2006/main" name="Struttura predefinita">
  <a:themeElements>
    <a:clrScheme name="Struttura predefinita 2">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Struttura predefinita">
      <a:majorFont>
        <a:latin typeface="Times New Roman"/>
        <a:ea typeface=""/>
        <a:cs typeface=""/>
      </a:majorFont>
      <a:minorFont>
        <a:latin typeface="Times New Roman"/>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solidFill>
          <a:schemeClr val="bg1"/>
        </a:solidFill>
        <a:ln w="9525">
          <a:solidFill>
            <a:schemeClr val="bg1"/>
          </a:solidFill>
          <a:miter lim="800000"/>
          <a:headEnd/>
          <a:tailEnd/>
        </a:ln>
      </a:spPr>
      <a:bodyPr wrap="none" anchor="ctr"/>
      <a:lstStyle>
        <a:defPPr>
          <a:defRPr sz="3600" dirty="0"/>
        </a:defPPr>
      </a:lstStyle>
    </a:spDef>
    <a:lnDef>
      <a:spPr bwMode="auto">
        <a:xfrm>
          <a:off x="0" y="0"/>
          <a:ext cx="1" cy="1"/>
        </a:xfrm>
        <a:custGeom>
          <a:avLst/>
          <a:gdLst/>
          <a:ahLst/>
          <a:cxnLst/>
          <a:rect l="0" t="0" r="0" b="0"/>
          <a:pathLst/>
        </a:custGeom>
        <a:solidFill>
          <a:schemeClr val="bg1"/>
        </a:solidFill>
        <a:ln w="9525" cap="sq" cmpd="sng" algn="ctr">
          <a:noFill/>
          <a:prstDash val="solid"/>
          <a:round/>
          <a:headEnd type="none" w="med" len="med"/>
          <a:tailEnd type="none" w="med" len="med"/>
        </a:ln>
        <a:effectLst/>
      </a:spPr>
      <a:bodyPr vert="horz" wrap="none" lIns="91440" tIns="45720" rIns="91440" bIns="45720" numCol="1" anchor="ctr" anchorCtr="0" compatLnSpc="1">
        <a:prstTxWarp prst="textNoShape">
          <a:avLst/>
        </a:prstTxWarp>
        <a:spAutoFit/>
      </a:bodyPr>
      <a:lstStyle>
        <a:defPPr marL="0" marR="0" indent="0" algn="ctr" defTabSz="914400" rtl="0" eaLnBrk="1" fontAlgn="base" latinLnBrk="0" hangingPunct="1">
          <a:lnSpc>
            <a:spcPct val="100000"/>
          </a:lnSpc>
          <a:spcBef>
            <a:spcPct val="0"/>
          </a:spcBef>
          <a:spcAft>
            <a:spcPct val="0"/>
          </a:spcAft>
          <a:buClrTx/>
          <a:buSzTx/>
          <a:buFontTx/>
          <a:buNone/>
          <a:tabLst/>
          <a:defRPr kumimoji="0" lang="it-IT" sz="3200" b="1" i="0" u="none" strike="noStrike" cap="none" normalizeH="0" baseline="0" smtClean="0">
            <a:ln>
              <a:noFill/>
            </a:ln>
            <a:solidFill>
              <a:schemeClr val="tx1"/>
            </a:solidFill>
            <a:effectLst/>
            <a:latin typeface="Times New Roman" pitchFamily="18" charset="0"/>
          </a:defRPr>
        </a:defPPr>
      </a:lstStyle>
    </a:lnDef>
  </a:objectDefaults>
  <a:extraClrSchemeLst>
    <a:extraClrScheme>
      <a:clrScheme name="Struttura predefinita 1">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Struttura predefinita 2">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Struttura predefinita 3">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Struttura predefinita 4">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Struttura predefinita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Struttura predefinita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Struttura predefinita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C:\Program Files\Microsoft Office\Templates\Presentation Designs\Contemporary.pot</Template>
  <TotalTime>25</TotalTime>
  <Words>48</Words>
  <Application>Microsoft Office PowerPoint</Application>
  <PresentationFormat>A4 Paper (210x297 mm)</PresentationFormat>
  <Paragraphs>2</Paragraphs>
  <Slides>1</Slides>
  <Notes>0</Notes>
  <HiddenSlides>0</HiddenSlides>
  <MMClips>1</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Calibri Light</vt:lpstr>
      <vt:lpstr>Times New Roman</vt:lpstr>
      <vt:lpstr>Struttura predefinita</vt:lpstr>
      <vt:lpstr>PowerPoint Presentation</vt:lpstr>
    </vt:vector>
  </TitlesOfParts>
  <Company>Coop. Sociale I Car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rieste meeting Dec 2001</dc:title>
  <dc:creator>Peter McNaughton</dc:creator>
  <cp:lastModifiedBy>McNaughton, Peter</cp:lastModifiedBy>
  <cp:revision>1</cp:revision>
  <dcterms:created xsi:type="dcterms:W3CDTF">2000-04-23T10:26:53Z</dcterms:created>
  <dcterms:modified xsi:type="dcterms:W3CDTF">2020-08-13T16:46:23Z</dcterms:modified>
</cp:coreProperties>
</file>